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drawings/drawing3.xml" ContentType="application/vnd.openxmlformats-officedocument.drawingml.chartshapes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drawings/drawing4.xml" ContentType="application/vnd.openxmlformats-officedocument.drawingml.chartshapes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drawings/drawing5.xml" ContentType="application/vnd.openxmlformats-officedocument.drawingml.chartshapes+xml"/>
  <Override PartName="/ppt/charts/chart9.xml" ContentType="application/vnd.openxmlformats-officedocument.drawingml.chart+xml"/>
  <Override PartName="/ppt/drawings/drawing6.xml" ContentType="application/vnd.openxmlformats-officedocument.drawingml.chartshapes+xml"/>
  <Override PartName="/ppt/charts/chart10.xml" ContentType="application/vnd.openxmlformats-officedocument.drawingml.chart+xml"/>
  <Override PartName="/ppt/drawings/drawing7.xml" ContentType="application/vnd.openxmlformats-officedocument.drawingml.chartshapes+xml"/>
  <Override PartName="/ppt/charts/chart11.xml" ContentType="application/vnd.openxmlformats-officedocument.drawingml.chart+xml"/>
  <Override PartName="/ppt/drawings/drawing8.xml" ContentType="application/vnd.openxmlformats-officedocument.drawingml.chartshapes+xml"/>
  <Override PartName="/ppt/charts/chart12.xml" ContentType="application/vnd.openxmlformats-officedocument.drawingml.chart+xml"/>
  <Override PartName="/ppt/drawings/drawing9.xml" ContentType="application/vnd.openxmlformats-officedocument.drawingml.chartshapes+xml"/>
  <Override PartName="/ppt/charts/chart13.xml" ContentType="application/vnd.openxmlformats-officedocument.drawingml.chart+xml"/>
  <Override PartName="/ppt/drawings/drawing10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57" r:id="rId2"/>
    <p:sldId id="258" r:id="rId3"/>
    <p:sldId id="259" r:id="rId4"/>
    <p:sldId id="264" r:id="rId5"/>
    <p:sldId id="261" r:id="rId6"/>
    <p:sldId id="263" r:id="rId7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84"/>
  </p:normalViewPr>
  <p:slideViewPr>
    <p:cSldViewPr snapToGrid="0" snapToObjects="1">
      <p:cViewPr varScale="1">
        <p:scale>
          <a:sx n="106" d="100"/>
          <a:sy n="106" d="100"/>
        </p:scale>
        <p:origin x="1800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______.xlsx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package" Target="../embeddings/Microsoft_Excel_______6.xlsx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oleObject" Target="file:///J:\&#30740;&#31350;\&#31185;&#30740;&#36027;H28&#12363;&#12425;&#12473;&#12508;&#12524;&#12461;&#12469;&#12531;&#12488;\2016&#31185;&#30740;&#12373;&#12392;&#12415;&#12398;&#12487;&#12540;&#12479;\&#30496;&#27671;&#12450;&#12531;&#12465;&#12540;&#12488;&#12414;&#12392;&#12417;&#65288;&#23436;&#25104;&#65289;2016-2.xlsx" TargetMode="Externa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oleObject" Target="file:///J:\&#30740;&#31350;\&#31185;&#30740;&#36027;H28&#12363;&#12425;&#12473;&#12508;&#12524;&#12461;&#12469;&#12531;&#12488;\2016&#31185;&#30740;&#12373;&#12392;&#12415;&#12398;&#12487;&#12540;&#12479;\&#30496;&#27671;&#12450;&#12531;&#12465;&#12540;&#12488;&#12414;&#12392;&#12417;&#65288;&#23436;&#25104;&#65289;2016-2.xlsx" TargetMode="External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0.xml"/><Relationship Id="rId1" Type="http://schemas.openxmlformats.org/officeDocument/2006/relationships/oleObject" Target="file:///F:\&#30740;&#31350;\&#31185;&#30740;&#36027;H28&#12363;&#12425;&#12473;&#12508;&#12524;&#12461;&#12469;&#12531;&#12488;\2016&#31185;&#30740;&#12373;&#12392;&#12415;&#12398;&#12487;&#12540;&#12479;\&#30496;&#27671;&#12450;&#12531;&#12465;&#12540;&#12488;&#12414;&#12392;&#12417;&#65288;&#23436;&#25104;&#65289;2016-2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______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2.xlsx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package" Target="../embeddings/Microsoft_Excel_______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30740;&#31350;\&#31185;&#30740;&#36027;H28&#12363;&#12425;&#12473;&#12508;&#12524;&#12461;&#12469;&#12531;&#12488;\2016&#31185;&#30740;&#12373;&#12392;&#12415;&#12398;&#12487;&#12540;&#12479;\&#37325;&#24515;&#21205;&#25594;&#12414;&#12392;&#12417;2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J:\&#30740;&#31350;\&#31185;&#30740;&#36027;H28&#12363;&#12425;&#12473;&#12508;&#12524;&#12461;&#12469;&#12531;&#12488;\2016&#31185;&#30740;&#12373;&#12392;&#12415;&#12398;&#12487;&#12540;&#12479;\CFF&#12414;&#12392;&#12417;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4.xlsx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package" Target="../embeddings/Microsoft_Excel_______5.xlsx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F:\&#30740;&#31350;\&#31185;&#30740;&#36027;H28&#12363;&#12425;&#12473;&#12508;&#12524;&#12461;&#12469;&#12531;&#12488;\2016&#31185;&#30740;&#12373;&#12392;&#12415;&#12398;&#12487;&#12540;&#12479;\&#12522;&#12502;&#12524;&#12483;&#12488;&#12414;&#12392;&#12417;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2854842297255"/>
          <c:y val="0.103210215030104"/>
          <c:w val="0.841947417589751"/>
          <c:h val="0.731423896680597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4D4-44AE-87CE-BA1C74F33A9C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accent3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4D4-44AE-87CE-BA1C74F33A9C}"/>
              </c:ext>
            </c:extLst>
          </c:dPt>
          <c:dPt>
            <c:idx val="3"/>
            <c:invertIfNegative val="0"/>
            <c:bubble3D val="0"/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4D4-44AE-87CE-BA1C74F33A9C}"/>
              </c:ext>
            </c:extLst>
          </c:dPt>
          <c:errBars>
            <c:errBarType val="both"/>
            <c:errValType val="cust"/>
            <c:noEndCap val="0"/>
            <c:plus>
              <c:numRef>
                <c:f>第3stage!$K$19:$N$19</c:f>
                <c:numCache>
                  <c:formatCode>General</c:formatCode>
                  <c:ptCount val="4"/>
                  <c:pt idx="0">
                    <c:v>6.7360895097846303</c:v>
                  </c:pt>
                  <c:pt idx="1">
                    <c:v>6.1113426212431401</c:v>
                  </c:pt>
                  <c:pt idx="2">
                    <c:v>5.0161247058226399</c:v>
                  </c:pt>
                  <c:pt idx="3">
                    <c:v>6.7299107997102396</c:v>
                  </c:pt>
                </c:numCache>
              </c:numRef>
            </c:plus>
            <c:minus>
              <c:numRef>
                <c:f>第3stage!$K$19:$N$19</c:f>
                <c:numCache>
                  <c:formatCode>General</c:formatCode>
                  <c:ptCount val="4"/>
                  <c:pt idx="0">
                    <c:v>6.7360895097846303</c:v>
                  </c:pt>
                  <c:pt idx="1">
                    <c:v>6.1113426212431401</c:v>
                  </c:pt>
                  <c:pt idx="2">
                    <c:v>5.0161247058226399</c:v>
                  </c:pt>
                  <c:pt idx="3">
                    <c:v>6.72991079971023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第3stage!$K$2:$N$2</c:f>
              <c:strCache>
                <c:ptCount val="4"/>
                <c:pt idx="0">
                  <c:v>Zolpidem</c:v>
                </c:pt>
                <c:pt idx="1">
                  <c:v>Suvorexanｔ</c:v>
                </c:pt>
                <c:pt idx="2">
                  <c:v>Ramelteon</c:v>
                </c:pt>
                <c:pt idx="3">
                  <c:v>Placebo</c:v>
                </c:pt>
              </c:strCache>
            </c:strRef>
          </c:cat>
          <c:val>
            <c:numRef>
              <c:f>第3stage!$K$17:$N$17</c:f>
              <c:numCache>
                <c:formatCode>General</c:formatCode>
                <c:ptCount val="4"/>
                <c:pt idx="0">
                  <c:v>26.964285714285719</c:v>
                </c:pt>
                <c:pt idx="1">
                  <c:v>26.071428571428569</c:v>
                </c:pt>
                <c:pt idx="2">
                  <c:v>18.55714285714285</c:v>
                </c:pt>
                <c:pt idx="3">
                  <c:v>28.1071428571428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4D4-44AE-87CE-BA1C74F33A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31247288"/>
        <c:axId val="-2131665192"/>
      </c:barChart>
      <c:catAx>
        <c:axId val="-2131247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31665192"/>
        <c:crosses val="autoZero"/>
        <c:auto val="1"/>
        <c:lblAlgn val="ctr"/>
        <c:lblOffset val="100"/>
        <c:noMultiLvlLbl val="0"/>
      </c:catAx>
      <c:valAx>
        <c:axId val="-21316651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31247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>
        <a:lumMod val="95000"/>
      </a:schemeClr>
    </a:solidFill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目覚め感2!$R$36</c:f>
              <c:strCache>
                <c:ptCount val="1"/>
                <c:pt idx="0">
                  <c:v>Zolpidem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目覚め感2!$AA$36:$AH$36</c:f>
                <c:numCache>
                  <c:formatCode>General</c:formatCode>
                  <c:ptCount val="8"/>
                  <c:pt idx="0">
                    <c:v>5.2429215195017456</c:v>
                  </c:pt>
                  <c:pt idx="1">
                    <c:v>3.839653061904523</c:v>
                  </c:pt>
                  <c:pt idx="2">
                    <c:v>6.3410402308131761</c:v>
                  </c:pt>
                  <c:pt idx="3">
                    <c:v>5.4889999889889669</c:v>
                  </c:pt>
                  <c:pt idx="4">
                    <c:v>5.630742315777522</c:v>
                  </c:pt>
                  <c:pt idx="5">
                    <c:v>4.9682271490653074</c:v>
                  </c:pt>
                  <c:pt idx="6">
                    <c:v>5.4746454262510129</c:v>
                  </c:pt>
                  <c:pt idx="7">
                    <c:v>6.50325965845155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目覚め感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目覚め感2!$S$36:$Z$36</c:f>
              <c:numCache>
                <c:formatCode>General</c:formatCode>
                <c:ptCount val="8"/>
                <c:pt idx="0">
                  <c:v>81.714285714285722</c:v>
                </c:pt>
                <c:pt idx="1">
                  <c:v>35.357142857142257</c:v>
                </c:pt>
                <c:pt idx="2">
                  <c:v>54</c:v>
                </c:pt>
                <c:pt idx="3">
                  <c:v>72.5</c:v>
                </c:pt>
                <c:pt idx="4">
                  <c:v>72.785714285714306</c:v>
                </c:pt>
                <c:pt idx="5">
                  <c:v>74.785714285714306</c:v>
                </c:pt>
                <c:pt idx="6">
                  <c:v>75.285714285714306</c:v>
                </c:pt>
                <c:pt idx="7">
                  <c:v>76.3571428571427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B9A-4B45-B36A-3CF8C33516B7}"/>
            </c:ext>
          </c:extLst>
        </c:ser>
        <c:ser>
          <c:idx val="1"/>
          <c:order val="1"/>
          <c:tx>
            <c:strRef>
              <c:f>目覚め感2!$R$37</c:f>
              <c:strCache>
                <c:ptCount val="1"/>
                <c:pt idx="0">
                  <c:v>Suvorexanｔ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目覚め感2!$AA$37:$AH$37</c:f>
                <c:numCache>
                  <c:formatCode>General</c:formatCode>
                  <c:ptCount val="8"/>
                  <c:pt idx="0">
                    <c:v>7.2815113927855206</c:v>
                  </c:pt>
                  <c:pt idx="1">
                    <c:v>6.6560780641630348</c:v>
                  </c:pt>
                  <c:pt idx="2">
                    <c:v>7.4141078553271544</c:v>
                  </c:pt>
                  <c:pt idx="3">
                    <c:v>6.4185514096096634</c:v>
                  </c:pt>
                  <c:pt idx="4">
                    <c:v>6.9183679257952084</c:v>
                  </c:pt>
                  <c:pt idx="5">
                    <c:v>7.5057539414238299</c:v>
                  </c:pt>
                  <c:pt idx="6">
                    <c:v>6.4332400629858579</c:v>
                  </c:pt>
                  <c:pt idx="7">
                    <c:v>6.0973589773946459</c:v>
                  </c:pt>
                </c:numCache>
              </c:numRef>
            </c:minus>
          </c:errBars>
          <c:cat>
            <c:numRef>
              <c:f>目覚め感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目覚め感2!$S$37:$Z$37</c:f>
              <c:numCache>
                <c:formatCode>General</c:formatCode>
                <c:ptCount val="8"/>
                <c:pt idx="0">
                  <c:v>70.857142857142748</c:v>
                </c:pt>
                <c:pt idx="1">
                  <c:v>39.642857142857153</c:v>
                </c:pt>
                <c:pt idx="2">
                  <c:v>47.785714285714278</c:v>
                </c:pt>
                <c:pt idx="3">
                  <c:v>64</c:v>
                </c:pt>
                <c:pt idx="4">
                  <c:v>58.357142857142257</c:v>
                </c:pt>
                <c:pt idx="5">
                  <c:v>64.357142857142748</c:v>
                </c:pt>
                <c:pt idx="6">
                  <c:v>61.785714285714278</c:v>
                </c:pt>
                <c:pt idx="7">
                  <c:v>73.7857142857143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B9A-4B45-B36A-3CF8C33516B7}"/>
            </c:ext>
          </c:extLst>
        </c:ser>
        <c:ser>
          <c:idx val="2"/>
          <c:order val="2"/>
          <c:tx>
            <c:strRef>
              <c:f>目覚め感2!$R$38</c:f>
              <c:strCache>
                <c:ptCount val="1"/>
                <c:pt idx="0">
                  <c:v>Ramelteon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目覚め感2!$AA$38:$AH$38</c:f>
                <c:numCache>
                  <c:formatCode>General</c:formatCode>
                  <c:ptCount val="8"/>
                  <c:pt idx="0">
                    <c:v>6.088727778892987</c:v>
                  </c:pt>
                  <c:pt idx="1">
                    <c:v>4.5686804926882356</c:v>
                  </c:pt>
                  <c:pt idx="2">
                    <c:v>5.2787673386297884</c:v>
                  </c:pt>
                  <c:pt idx="3">
                    <c:v>6.8112014122457847</c:v>
                  </c:pt>
                  <c:pt idx="4">
                    <c:v>7.5418247711757944</c:v>
                  </c:pt>
                  <c:pt idx="5">
                    <c:v>6.1101865688215824</c:v>
                  </c:pt>
                  <c:pt idx="6">
                    <c:v>7.7346089638827777</c:v>
                  </c:pt>
                  <c:pt idx="7">
                    <c:v>6.1496576208763916</c:v>
                  </c:pt>
                </c:numCache>
              </c:numRef>
            </c:minus>
          </c:errBars>
          <c:cat>
            <c:numRef>
              <c:f>目覚め感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目覚め感2!$S$38:$Z$38</c:f>
              <c:numCache>
                <c:formatCode>General</c:formatCode>
                <c:ptCount val="8"/>
                <c:pt idx="0">
                  <c:v>76.642857142856045</c:v>
                </c:pt>
                <c:pt idx="1">
                  <c:v>33.714285714285722</c:v>
                </c:pt>
                <c:pt idx="2">
                  <c:v>46.5</c:v>
                </c:pt>
                <c:pt idx="3">
                  <c:v>63.428571428571431</c:v>
                </c:pt>
                <c:pt idx="4">
                  <c:v>61</c:v>
                </c:pt>
                <c:pt idx="5">
                  <c:v>66.285714285714306</c:v>
                </c:pt>
                <c:pt idx="6">
                  <c:v>64</c:v>
                </c:pt>
                <c:pt idx="7">
                  <c:v>68.9285714285712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B9A-4B45-B36A-3CF8C33516B7}"/>
            </c:ext>
          </c:extLst>
        </c:ser>
        <c:ser>
          <c:idx val="3"/>
          <c:order val="3"/>
          <c:tx>
            <c:strRef>
              <c:f>目覚め感2!$R$39</c:f>
              <c:strCache>
                <c:ptCount val="1"/>
                <c:pt idx="0">
                  <c:v>Placebo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目覚め感2!$AA$39:$AH$39</c:f>
                <c:numCache>
                  <c:formatCode>General</c:formatCode>
                  <c:ptCount val="8"/>
                  <c:pt idx="0">
                    <c:v>6.751853051069304</c:v>
                  </c:pt>
                  <c:pt idx="1">
                    <c:v>6.4488081967566471</c:v>
                  </c:pt>
                  <c:pt idx="2">
                    <c:v>6.7434775743616404</c:v>
                  </c:pt>
                  <c:pt idx="3">
                    <c:v>6.4762578104665911</c:v>
                  </c:pt>
                  <c:pt idx="4">
                    <c:v>6.2979401581373269</c:v>
                  </c:pt>
                  <c:pt idx="5">
                    <c:v>7.7850085374253837</c:v>
                  </c:pt>
                  <c:pt idx="6">
                    <c:v>6.6229762763179494</c:v>
                  </c:pt>
                  <c:pt idx="7">
                    <c:v>7.37746579591249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目覚め感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目覚め感2!$S$39:$Z$39</c:f>
              <c:numCache>
                <c:formatCode>General</c:formatCode>
                <c:ptCount val="8"/>
                <c:pt idx="0">
                  <c:v>71.928571428571246</c:v>
                </c:pt>
                <c:pt idx="1">
                  <c:v>40.714285714285722</c:v>
                </c:pt>
                <c:pt idx="2">
                  <c:v>45.214285714285722</c:v>
                </c:pt>
                <c:pt idx="3">
                  <c:v>63.571428571428292</c:v>
                </c:pt>
                <c:pt idx="4">
                  <c:v>63.285714285714278</c:v>
                </c:pt>
                <c:pt idx="5">
                  <c:v>66.214285714285722</c:v>
                </c:pt>
                <c:pt idx="6">
                  <c:v>69.642857142856045</c:v>
                </c:pt>
                <c:pt idx="7">
                  <c:v>71.8571428571427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B9A-4B45-B36A-3CF8C33516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124623064"/>
        <c:axId val="2071801080"/>
      </c:lineChart>
      <c:catAx>
        <c:axId val="-2124623064"/>
        <c:scaling>
          <c:orientation val="minMax"/>
        </c:scaling>
        <c:delete val="0"/>
        <c:axPos val="b"/>
        <c:numFmt formatCode="h:mm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2071801080"/>
        <c:crosses val="autoZero"/>
        <c:auto val="1"/>
        <c:lblAlgn val="ctr"/>
        <c:lblOffset val="100"/>
        <c:noMultiLvlLbl val="0"/>
      </c:catAx>
      <c:valAx>
        <c:axId val="2071801080"/>
        <c:scaling>
          <c:orientation val="minMax"/>
          <c:min val="30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ja-JP"/>
                </a:pPr>
                <a:r>
                  <a:rPr lang="ja-JP" altLang="en-US"/>
                  <a:t>ｃｍ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124623064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気分居心地2!$R$36</c:f>
              <c:strCache>
                <c:ptCount val="1"/>
                <c:pt idx="0">
                  <c:v>Zolpidem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気分居心地2!$AA$36:$AH$36</c:f>
                <c:numCache>
                  <c:formatCode>General</c:formatCode>
                  <c:ptCount val="8"/>
                  <c:pt idx="0">
                    <c:v>5.6375688114302056</c:v>
                  </c:pt>
                  <c:pt idx="1">
                    <c:v>4.0824027923356301</c:v>
                  </c:pt>
                  <c:pt idx="2">
                    <c:v>5.9220472509151856</c:v>
                  </c:pt>
                  <c:pt idx="3">
                    <c:v>5.1970587020233214</c:v>
                  </c:pt>
                  <c:pt idx="4">
                    <c:v>5.0269680885465471</c:v>
                  </c:pt>
                  <c:pt idx="5">
                    <c:v>4.8284950250798966</c:v>
                  </c:pt>
                  <c:pt idx="6">
                    <c:v>4.7228111390298846</c:v>
                  </c:pt>
                  <c:pt idx="7">
                    <c:v>6.42127180192211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気分居心地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気分居心地2!$S$36:$Z$36</c:f>
              <c:numCache>
                <c:formatCode>General</c:formatCode>
                <c:ptCount val="8"/>
                <c:pt idx="0">
                  <c:v>76.785714285714306</c:v>
                </c:pt>
                <c:pt idx="1">
                  <c:v>40.642857142857153</c:v>
                </c:pt>
                <c:pt idx="2">
                  <c:v>51.714285714285722</c:v>
                </c:pt>
                <c:pt idx="3">
                  <c:v>73.142857142856045</c:v>
                </c:pt>
                <c:pt idx="4">
                  <c:v>69.357142857142748</c:v>
                </c:pt>
                <c:pt idx="5">
                  <c:v>75.357142857142748</c:v>
                </c:pt>
                <c:pt idx="6">
                  <c:v>75.5</c:v>
                </c:pt>
                <c:pt idx="7">
                  <c:v>71.2142857142857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086-4611-8184-0A8C728820CB}"/>
            </c:ext>
          </c:extLst>
        </c:ser>
        <c:ser>
          <c:idx val="1"/>
          <c:order val="1"/>
          <c:tx>
            <c:strRef>
              <c:f>気分居心地2!$R$37</c:f>
              <c:strCache>
                <c:ptCount val="1"/>
                <c:pt idx="0">
                  <c:v>Suvorexanｔ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気分居心地2!$AA$37:$AH$37</c:f>
                <c:numCache>
                  <c:formatCode>General</c:formatCode>
                  <c:ptCount val="8"/>
                  <c:pt idx="0">
                    <c:v>6.924718539015366</c:v>
                  </c:pt>
                  <c:pt idx="1">
                    <c:v>6.6551050977315347</c:v>
                  </c:pt>
                  <c:pt idx="2">
                    <c:v>7.1877708808419056</c:v>
                  </c:pt>
                  <c:pt idx="3">
                    <c:v>5.9204565142833054</c:v>
                  </c:pt>
                  <c:pt idx="4">
                    <c:v>5.6499121289064247</c:v>
                  </c:pt>
                  <c:pt idx="5">
                    <c:v>5.2653304612874736</c:v>
                  </c:pt>
                  <c:pt idx="6">
                    <c:v>6.4174506986332016</c:v>
                  </c:pt>
                  <c:pt idx="7">
                    <c:v>6.211127149797985</c:v>
                  </c:pt>
                </c:numCache>
              </c:numRef>
            </c:minus>
          </c:errBars>
          <c:cat>
            <c:numRef>
              <c:f>気分居心地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気分居心地2!$S$37:$Z$37</c:f>
              <c:numCache>
                <c:formatCode>General</c:formatCode>
                <c:ptCount val="8"/>
                <c:pt idx="0">
                  <c:v>68.642857142856045</c:v>
                </c:pt>
                <c:pt idx="1">
                  <c:v>40.714285714285722</c:v>
                </c:pt>
                <c:pt idx="2">
                  <c:v>49.714285714285722</c:v>
                </c:pt>
                <c:pt idx="3">
                  <c:v>64.571428571427944</c:v>
                </c:pt>
                <c:pt idx="4">
                  <c:v>59.857142857142257</c:v>
                </c:pt>
                <c:pt idx="5">
                  <c:v>70.142857142856045</c:v>
                </c:pt>
                <c:pt idx="6">
                  <c:v>64.571428571427944</c:v>
                </c:pt>
                <c:pt idx="7">
                  <c:v>71.3571428571427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086-4611-8184-0A8C728820CB}"/>
            </c:ext>
          </c:extLst>
        </c:ser>
        <c:ser>
          <c:idx val="2"/>
          <c:order val="2"/>
          <c:tx>
            <c:strRef>
              <c:f>気分居心地2!$R$38</c:f>
              <c:strCache>
                <c:ptCount val="1"/>
                <c:pt idx="0">
                  <c:v>Ramelteon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気分居心地2!$AA$38:$AH$38</c:f>
                <c:numCache>
                  <c:formatCode>General</c:formatCode>
                  <c:ptCount val="8"/>
                  <c:pt idx="0">
                    <c:v>5.4596061985288031</c:v>
                  </c:pt>
                  <c:pt idx="1">
                    <c:v>4.3557014369501159</c:v>
                  </c:pt>
                  <c:pt idx="2">
                    <c:v>4.6414621742075717</c:v>
                  </c:pt>
                  <c:pt idx="3">
                    <c:v>5.9417634242930699</c:v>
                  </c:pt>
                  <c:pt idx="4">
                    <c:v>6.6691256584851413</c:v>
                  </c:pt>
                  <c:pt idx="5">
                    <c:v>4.6287613581978766</c:v>
                  </c:pt>
                  <c:pt idx="6">
                    <c:v>6.0824076555702851</c:v>
                  </c:pt>
                  <c:pt idx="7">
                    <c:v>6.0344380600149474</c:v>
                  </c:pt>
                </c:numCache>
              </c:numRef>
            </c:minus>
          </c:errBars>
          <c:cat>
            <c:numRef>
              <c:f>気分居心地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気分居心地2!$S$38:$Z$38</c:f>
              <c:numCache>
                <c:formatCode>General</c:formatCode>
                <c:ptCount val="8"/>
                <c:pt idx="0">
                  <c:v>74.071428571427944</c:v>
                </c:pt>
                <c:pt idx="1">
                  <c:v>37.071428571428292</c:v>
                </c:pt>
                <c:pt idx="2">
                  <c:v>47.714285714285722</c:v>
                </c:pt>
                <c:pt idx="3">
                  <c:v>63.571428571428292</c:v>
                </c:pt>
                <c:pt idx="4">
                  <c:v>59.285714285714278</c:v>
                </c:pt>
                <c:pt idx="5">
                  <c:v>65.428571428571246</c:v>
                </c:pt>
                <c:pt idx="6">
                  <c:v>64.357142857142748</c:v>
                </c:pt>
                <c:pt idx="7">
                  <c:v>64.5714285714279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086-4611-8184-0A8C728820CB}"/>
            </c:ext>
          </c:extLst>
        </c:ser>
        <c:ser>
          <c:idx val="3"/>
          <c:order val="3"/>
          <c:tx>
            <c:strRef>
              <c:f>気分居心地2!$R$39</c:f>
              <c:strCache>
                <c:ptCount val="1"/>
                <c:pt idx="0">
                  <c:v>Placebo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気分居心地2!$AA$39:$AH$39</c:f>
                <c:numCache>
                  <c:formatCode>General</c:formatCode>
                  <c:ptCount val="8"/>
                  <c:pt idx="0">
                    <c:v>5.7709076579193637</c:v>
                  </c:pt>
                  <c:pt idx="1">
                    <c:v>6.5530081052620099</c:v>
                  </c:pt>
                  <c:pt idx="2">
                    <c:v>6.2439924031262466</c:v>
                  </c:pt>
                  <c:pt idx="3">
                    <c:v>6.1699186695874797</c:v>
                  </c:pt>
                  <c:pt idx="4">
                    <c:v>5.9362455297107601</c:v>
                  </c:pt>
                  <c:pt idx="5">
                    <c:v>6.1705229290725754</c:v>
                  </c:pt>
                  <c:pt idx="6">
                    <c:v>5.5683634848606198</c:v>
                  </c:pt>
                  <c:pt idx="7">
                    <c:v>7.1292452719461643</c:v>
                  </c:pt>
                </c:numCache>
              </c:numRef>
            </c:minus>
          </c:errBars>
          <c:cat>
            <c:numRef>
              <c:f>気分居心地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気分居心地2!$S$39:$Z$39</c:f>
              <c:numCache>
                <c:formatCode>General</c:formatCode>
                <c:ptCount val="8"/>
                <c:pt idx="0">
                  <c:v>69.357142857142748</c:v>
                </c:pt>
                <c:pt idx="1">
                  <c:v>43.428571428571431</c:v>
                </c:pt>
                <c:pt idx="2">
                  <c:v>47.142857142857153</c:v>
                </c:pt>
                <c:pt idx="3">
                  <c:v>64.214285714285722</c:v>
                </c:pt>
                <c:pt idx="4">
                  <c:v>62.5</c:v>
                </c:pt>
                <c:pt idx="5">
                  <c:v>68.857142857142748</c:v>
                </c:pt>
                <c:pt idx="6">
                  <c:v>70.357142857142748</c:v>
                </c:pt>
                <c:pt idx="7">
                  <c:v>69.7857142857143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086-4611-8184-0A8C728820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42197144"/>
        <c:axId val="-2046028568"/>
      </c:lineChart>
      <c:catAx>
        <c:axId val="1842197144"/>
        <c:scaling>
          <c:orientation val="minMax"/>
        </c:scaling>
        <c:delete val="0"/>
        <c:axPos val="b"/>
        <c:numFmt formatCode="h:mm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046028568"/>
        <c:crosses val="autoZero"/>
        <c:auto val="1"/>
        <c:lblAlgn val="ctr"/>
        <c:lblOffset val="100"/>
        <c:noMultiLvlLbl val="0"/>
      </c:catAx>
      <c:valAx>
        <c:axId val="-2046028568"/>
        <c:scaling>
          <c:orientation val="minMax"/>
          <c:min val="30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ja-JP"/>
                </a:pPr>
                <a:r>
                  <a:rPr lang="ja-JP" altLang="en-US"/>
                  <a:t>ｃｍ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1842197144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疲労感2!$R$36</c:f>
              <c:strCache>
                <c:ptCount val="1"/>
                <c:pt idx="0">
                  <c:v>Zolpidem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疲労感2!$AA$36:$AH$36</c:f>
                <c:numCache>
                  <c:formatCode>General</c:formatCode>
                  <c:ptCount val="8"/>
                  <c:pt idx="0">
                    <c:v>5.0586823260589444</c:v>
                  </c:pt>
                  <c:pt idx="1">
                    <c:v>4.0402216393187462</c:v>
                  </c:pt>
                  <c:pt idx="2">
                    <c:v>6.1491151358934628</c:v>
                  </c:pt>
                  <c:pt idx="3">
                    <c:v>4.4163247895486402</c:v>
                  </c:pt>
                  <c:pt idx="4">
                    <c:v>5.5597228396184626</c:v>
                  </c:pt>
                  <c:pt idx="5">
                    <c:v>4.6632266606438977</c:v>
                  </c:pt>
                  <c:pt idx="6">
                    <c:v>5.2180101105060874</c:v>
                  </c:pt>
                  <c:pt idx="7">
                    <c:v>6.48561383472581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疲労感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疲労感2!$S$36:$Z$36</c:f>
              <c:numCache>
                <c:formatCode>General</c:formatCode>
                <c:ptCount val="8"/>
                <c:pt idx="0">
                  <c:v>80.428571428571246</c:v>
                </c:pt>
                <c:pt idx="1">
                  <c:v>43.285714285714278</c:v>
                </c:pt>
                <c:pt idx="2">
                  <c:v>51.142857142857153</c:v>
                </c:pt>
                <c:pt idx="3">
                  <c:v>73.857142857142748</c:v>
                </c:pt>
                <c:pt idx="4">
                  <c:v>68.142857142856045</c:v>
                </c:pt>
                <c:pt idx="5">
                  <c:v>74.857142857142748</c:v>
                </c:pt>
                <c:pt idx="6">
                  <c:v>74.428571428571246</c:v>
                </c:pt>
                <c:pt idx="7">
                  <c:v>67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B63-4FDE-B326-5E9D0F961F1C}"/>
            </c:ext>
          </c:extLst>
        </c:ser>
        <c:ser>
          <c:idx val="1"/>
          <c:order val="1"/>
          <c:tx>
            <c:strRef>
              <c:f>疲労感2!$R$37</c:f>
              <c:strCache>
                <c:ptCount val="1"/>
                <c:pt idx="0">
                  <c:v>Suvorexanｔ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疲労感2!$AA$37:$AH$37</c:f>
                <c:numCache>
                  <c:formatCode>General</c:formatCode>
                  <c:ptCount val="8"/>
                  <c:pt idx="0">
                    <c:v>8.345300146602975</c:v>
                  </c:pt>
                  <c:pt idx="1">
                    <c:v>7.1981377323017854</c:v>
                  </c:pt>
                  <c:pt idx="2">
                    <c:v>7.2223054108372846</c:v>
                  </c:pt>
                  <c:pt idx="3">
                    <c:v>6.1695370015250246</c:v>
                  </c:pt>
                  <c:pt idx="4">
                    <c:v>4.9886842125639168</c:v>
                  </c:pt>
                  <c:pt idx="5">
                    <c:v>5.4676155192412654</c:v>
                  </c:pt>
                  <c:pt idx="6">
                    <c:v>6.2286369590261854</c:v>
                  </c:pt>
                  <c:pt idx="7">
                    <c:v>6.69640476186243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疲労感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疲労感2!$S$37:$Z$37</c:f>
              <c:numCache>
                <c:formatCode>General</c:formatCode>
                <c:ptCount val="8"/>
                <c:pt idx="0">
                  <c:v>64.642857142856045</c:v>
                </c:pt>
                <c:pt idx="1">
                  <c:v>42</c:v>
                </c:pt>
                <c:pt idx="2">
                  <c:v>51.571428571428292</c:v>
                </c:pt>
                <c:pt idx="3">
                  <c:v>63.5</c:v>
                </c:pt>
                <c:pt idx="4">
                  <c:v>58.428571428571431</c:v>
                </c:pt>
                <c:pt idx="5">
                  <c:v>67.714285714285722</c:v>
                </c:pt>
                <c:pt idx="6">
                  <c:v>62.714285714285722</c:v>
                </c:pt>
                <c:pt idx="7">
                  <c:v>68.6428571428560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B63-4FDE-B326-5E9D0F961F1C}"/>
            </c:ext>
          </c:extLst>
        </c:ser>
        <c:ser>
          <c:idx val="2"/>
          <c:order val="2"/>
          <c:tx>
            <c:strRef>
              <c:f>疲労感2!$R$38</c:f>
              <c:strCache>
                <c:ptCount val="1"/>
                <c:pt idx="0">
                  <c:v>Ramelteon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疲労感2!$AA$38:$AH$38</c:f>
                <c:numCache>
                  <c:formatCode>General</c:formatCode>
                  <c:ptCount val="8"/>
                  <c:pt idx="0">
                    <c:v>5.4114826459115299</c:v>
                  </c:pt>
                  <c:pt idx="1">
                    <c:v>4.3011170101872036</c:v>
                  </c:pt>
                  <c:pt idx="2">
                    <c:v>4.9610729583386703</c:v>
                  </c:pt>
                  <c:pt idx="3">
                    <c:v>5.9531135080359636</c:v>
                  </c:pt>
                  <c:pt idx="4">
                    <c:v>6.9405696498460543</c:v>
                  </c:pt>
                  <c:pt idx="5">
                    <c:v>5.4922522852501201</c:v>
                  </c:pt>
                  <c:pt idx="6">
                    <c:v>6.404349973816795</c:v>
                  </c:pt>
                  <c:pt idx="7">
                    <c:v>6.2658276824622972</c:v>
                  </c:pt>
                </c:numCache>
              </c:numRef>
            </c:minus>
          </c:errBars>
          <c:cat>
            <c:numRef>
              <c:f>疲労感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疲労感2!$S$38:$Z$38</c:f>
              <c:numCache>
                <c:formatCode>General</c:formatCode>
                <c:ptCount val="8"/>
                <c:pt idx="0">
                  <c:v>72.142857142856045</c:v>
                </c:pt>
                <c:pt idx="1">
                  <c:v>37.928571428571431</c:v>
                </c:pt>
                <c:pt idx="2">
                  <c:v>48.428571428571431</c:v>
                </c:pt>
                <c:pt idx="3">
                  <c:v>65</c:v>
                </c:pt>
                <c:pt idx="4">
                  <c:v>58.642857142857153</c:v>
                </c:pt>
                <c:pt idx="5">
                  <c:v>63</c:v>
                </c:pt>
                <c:pt idx="6">
                  <c:v>64.285714285714306</c:v>
                </c:pt>
                <c:pt idx="7">
                  <c:v>59.4285714285714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B63-4FDE-B326-5E9D0F961F1C}"/>
            </c:ext>
          </c:extLst>
        </c:ser>
        <c:ser>
          <c:idx val="3"/>
          <c:order val="3"/>
          <c:tx>
            <c:strRef>
              <c:f>疲労感2!$R$39</c:f>
              <c:strCache>
                <c:ptCount val="1"/>
                <c:pt idx="0">
                  <c:v>Placebo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疲労感2!$AA$39:$AH$39</c:f>
                <c:numCache>
                  <c:formatCode>General</c:formatCode>
                  <c:ptCount val="8"/>
                  <c:pt idx="0">
                    <c:v>5.914222009531092</c:v>
                  </c:pt>
                  <c:pt idx="1">
                    <c:v>5.8335426440731402</c:v>
                  </c:pt>
                  <c:pt idx="2">
                    <c:v>6.2131172325719746</c:v>
                  </c:pt>
                  <c:pt idx="3">
                    <c:v>6.1359851671709356</c:v>
                  </c:pt>
                  <c:pt idx="4">
                    <c:v>6.3704330765198049</c:v>
                  </c:pt>
                  <c:pt idx="5">
                    <c:v>7.0269999583351854</c:v>
                  </c:pt>
                  <c:pt idx="6">
                    <c:v>5.6779061743157246</c:v>
                  </c:pt>
                  <c:pt idx="7">
                    <c:v>7.3747256022177696</c:v>
                  </c:pt>
                </c:numCache>
              </c:numRef>
            </c:minus>
          </c:errBars>
          <c:cat>
            <c:numRef>
              <c:f>疲労感2!$S$35:$Z$35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疲労感2!$S$39:$Z$39</c:f>
              <c:numCache>
                <c:formatCode>General</c:formatCode>
                <c:ptCount val="8"/>
                <c:pt idx="0">
                  <c:v>68</c:v>
                </c:pt>
                <c:pt idx="1">
                  <c:v>40.5</c:v>
                </c:pt>
                <c:pt idx="2">
                  <c:v>48.857142857142257</c:v>
                </c:pt>
                <c:pt idx="3">
                  <c:v>59.785714285714278</c:v>
                </c:pt>
                <c:pt idx="4">
                  <c:v>62</c:v>
                </c:pt>
                <c:pt idx="5">
                  <c:v>61.071428571428292</c:v>
                </c:pt>
                <c:pt idx="6">
                  <c:v>66.428571428571246</c:v>
                </c:pt>
                <c:pt idx="7">
                  <c:v>65.2142857142857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B63-4FDE-B326-5E9D0F961F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069115272"/>
        <c:axId val="-2125216344"/>
      </c:lineChart>
      <c:catAx>
        <c:axId val="-2069115272"/>
        <c:scaling>
          <c:orientation val="minMax"/>
        </c:scaling>
        <c:delete val="0"/>
        <c:axPos val="b"/>
        <c:numFmt formatCode="h:mm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125216344"/>
        <c:crosses val="autoZero"/>
        <c:auto val="1"/>
        <c:lblAlgn val="ctr"/>
        <c:lblOffset val="100"/>
        <c:noMultiLvlLbl val="0"/>
      </c:catAx>
      <c:valAx>
        <c:axId val="-2125216344"/>
        <c:scaling>
          <c:orientation val="minMax"/>
          <c:min val="30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ja-JP"/>
                </a:pPr>
                <a:r>
                  <a:rPr lang="ja-JP" altLang="en-US"/>
                  <a:t>ｃｍ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069115272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SSS2'!$X$49</c:f>
              <c:strCache>
                <c:ptCount val="1"/>
                <c:pt idx="0">
                  <c:v>Zolpidem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SSS2'!$AG$49:$AN$49</c:f>
                <c:numCache>
                  <c:formatCode>General</c:formatCode>
                  <c:ptCount val="8"/>
                  <c:pt idx="0">
                    <c:v>0.245045089241514</c:v>
                  </c:pt>
                  <c:pt idx="1">
                    <c:v>0.29115695163718203</c:v>
                  </c:pt>
                  <c:pt idx="2">
                    <c:v>0.30754509822322001</c:v>
                  </c:pt>
                  <c:pt idx="3">
                    <c:v>0.202030508910442</c:v>
                  </c:pt>
                  <c:pt idx="4">
                    <c:v>0.16926287693131201</c:v>
                  </c:pt>
                  <c:pt idx="5">
                    <c:v>0.22760785909019801</c:v>
                  </c:pt>
                  <c:pt idx="6">
                    <c:v>0.22846838336584399</c:v>
                  </c:pt>
                  <c:pt idx="7">
                    <c:v>0.22760785909019801</c:v>
                  </c:pt>
                </c:numCache>
              </c:numRef>
            </c:minus>
          </c:errBars>
          <c:cat>
            <c:numRef>
              <c:f>'SSS2'!$Y$48:$AF$48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'SSS2'!$Y$49:$AF$49</c:f>
              <c:numCache>
                <c:formatCode>General</c:formatCode>
                <c:ptCount val="8"/>
                <c:pt idx="0">
                  <c:v>2.0714285714285712</c:v>
                </c:pt>
                <c:pt idx="1">
                  <c:v>4.4285714285714288</c:v>
                </c:pt>
                <c:pt idx="2">
                  <c:v>3.3571428571428572</c:v>
                </c:pt>
                <c:pt idx="3">
                  <c:v>2.5714285714285712</c:v>
                </c:pt>
                <c:pt idx="4">
                  <c:v>2.6428571428571428</c:v>
                </c:pt>
                <c:pt idx="5">
                  <c:v>2.4285714285714302</c:v>
                </c:pt>
                <c:pt idx="6">
                  <c:v>2.5</c:v>
                </c:pt>
                <c:pt idx="7">
                  <c:v>2.57142857142857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00E-4A2A-8DC8-4DB1CDB536D8}"/>
            </c:ext>
          </c:extLst>
        </c:ser>
        <c:ser>
          <c:idx val="1"/>
          <c:order val="1"/>
          <c:tx>
            <c:strRef>
              <c:f>'SSS2'!$X$50</c:f>
              <c:strCache>
                <c:ptCount val="1"/>
                <c:pt idx="0">
                  <c:v>Suvorexanｔ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SSS2'!$AG$50:$AN$50</c:f>
                <c:numCache>
                  <c:formatCode>General</c:formatCode>
                  <c:ptCount val="8"/>
                  <c:pt idx="0">
                    <c:v>0.16926287693131201</c:v>
                  </c:pt>
                  <c:pt idx="1">
                    <c:v>0.36096852100344701</c:v>
                  </c:pt>
                  <c:pt idx="2">
                    <c:v>0.35438495596916703</c:v>
                  </c:pt>
                  <c:pt idx="3">
                    <c:v>0.238552674132884</c:v>
                  </c:pt>
                  <c:pt idx="4">
                    <c:v>0.26652599638758001</c:v>
                  </c:pt>
                  <c:pt idx="5">
                    <c:v>0.299790612433049</c:v>
                  </c:pt>
                  <c:pt idx="6">
                    <c:v>0.221490597480729</c:v>
                  </c:pt>
                  <c:pt idx="7">
                    <c:v>0.22760785909019801</c:v>
                  </c:pt>
                </c:numCache>
              </c:numRef>
            </c:minus>
          </c:errBars>
          <c:cat>
            <c:numRef>
              <c:f>'SSS2'!$Y$48:$AF$48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'SSS2'!$Y$50:$AF$50</c:f>
              <c:numCache>
                <c:formatCode>General</c:formatCode>
                <c:ptCount val="8"/>
                <c:pt idx="0">
                  <c:v>2.3571428571428572</c:v>
                </c:pt>
                <c:pt idx="1">
                  <c:v>4.1428571428571406</c:v>
                </c:pt>
                <c:pt idx="2">
                  <c:v>3.714285714285714</c:v>
                </c:pt>
                <c:pt idx="3">
                  <c:v>2.785714285714286</c:v>
                </c:pt>
                <c:pt idx="4">
                  <c:v>3.0714285714285712</c:v>
                </c:pt>
                <c:pt idx="5">
                  <c:v>2.785714285714286</c:v>
                </c:pt>
                <c:pt idx="6">
                  <c:v>2.9285714285714302</c:v>
                </c:pt>
                <c:pt idx="7">
                  <c:v>2.57142857142857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00E-4A2A-8DC8-4DB1CDB536D8}"/>
            </c:ext>
          </c:extLst>
        </c:ser>
        <c:ser>
          <c:idx val="2"/>
          <c:order val="2"/>
          <c:tx>
            <c:strRef>
              <c:f>'SSS2'!$X$51</c:f>
              <c:strCache>
                <c:ptCount val="1"/>
                <c:pt idx="0">
                  <c:v>Ramelteon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SSS2'!$AG$51:$AN$51</c:f>
                <c:numCache>
                  <c:formatCode>General</c:formatCode>
                  <c:ptCount val="8"/>
                  <c:pt idx="0">
                    <c:v>0.22500654098289299</c:v>
                  </c:pt>
                  <c:pt idx="1">
                    <c:v>0.24822762633135201</c:v>
                  </c:pt>
                  <c:pt idx="2">
                    <c:v>0.18689397089774701</c:v>
                  </c:pt>
                  <c:pt idx="3">
                    <c:v>0.18689397089774701</c:v>
                  </c:pt>
                  <c:pt idx="4">
                    <c:v>0.26578871697687501</c:v>
                  </c:pt>
                  <c:pt idx="5">
                    <c:v>0.27450540652300598</c:v>
                  </c:pt>
                  <c:pt idx="6">
                    <c:v>0.25677629550654801</c:v>
                  </c:pt>
                  <c:pt idx="7">
                    <c:v>0.2214905974807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SSS2'!$Y$48:$AF$48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'SSS2'!$Y$51:$AF$51</c:f>
              <c:numCache>
                <c:formatCode>General</c:formatCode>
                <c:ptCount val="8"/>
                <c:pt idx="0">
                  <c:v>2.3571428571428572</c:v>
                </c:pt>
                <c:pt idx="1">
                  <c:v>4.3571428571428346</c:v>
                </c:pt>
                <c:pt idx="2">
                  <c:v>3.785714285714286</c:v>
                </c:pt>
                <c:pt idx="3">
                  <c:v>2.785714285714286</c:v>
                </c:pt>
                <c:pt idx="4">
                  <c:v>3.285714285714286</c:v>
                </c:pt>
                <c:pt idx="5">
                  <c:v>2.8571428571428572</c:v>
                </c:pt>
                <c:pt idx="6">
                  <c:v>3</c:v>
                </c:pt>
                <c:pt idx="7">
                  <c:v>2.92857142857143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00E-4A2A-8DC8-4DB1CDB536D8}"/>
            </c:ext>
          </c:extLst>
        </c:ser>
        <c:ser>
          <c:idx val="3"/>
          <c:order val="3"/>
          <c:tx>
            <c:strRef>
              <c:f>'SSS2'!$X$52</c:f>
              <c:strCache>
                <c:ptCount val="1"/>
                <c:pt idx="0">
                  <c:v>Placebo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SSS2'!$AG$52:$AN$52</c:f>
                <c:numCache>
                  <c:formatCode>General</c:formatCode>
                  <c:ptCount val="8"/>
                  <c:pt idx="0">
                    <c:v>0.16926287693131201</c:v>
                  </c:pt>
                  <c:pt idx="1">
                    <c:v>0.38414413830656102</c:v>
                  </c:pt>
                  <c:pt idx="2">
                    <c:v>0.36096852100344701</c:v>
                  </c:pt>
                  <c:pt idx="3">
                    <c:v>0.214285714285714</c:v>
                  </c:pt>
                  <c:pt idx="4">
                    <c:v>0.23440361546924801</c:v>
                  </c:pt>
                  <c:pt idx="5">
                    <c:v>0.38465462908103598</c:v>
                  </c:pt>
                  <c:pt idx="6">
                    <c:v>0.202030508910442</c:v>
                  </c:pt>
                  <c:pt idx="7">
                    <c:v>0.2716309251496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SSS2'!$Y$48:$AF$48</c:f>
              <c:numCache>
                <c:formatCode>h:mm</c:formatCode>
                <c:ptCount val="8"/>
                <c:pt idx="0">
                  <c:v>0.875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33333333333333298</c:v>
                </c:pt>
                <c:pt idx="4">
                  <c:v>0.41666666666666702</c:v>
                </c:pt>
                <c:pt idx="5">
                  <c:v>0.5</c:v>
                </c:pt>
                <c:pt idx="6">
                  <c:v>0.58333333333333304</c:v>
                </c:pt>
                <c:pt idx="7">
                  <c:v>0.66666666666666696</c:v>
                </c:pt>
              </c:numCache>
            </c:numRef>
          </c:cat>
          <c:val>
            <c:numRef>
              <c:f>'SSS2'!$Y$52:$AF$52</c:f>
              <c:numCache>
                <c:formatCode>General</c:formatCode>
                <c:ptCount val="8"/>
                <c:pt idx="0">
                  <c:v>2.3571428571428572</c:v>
                </c:pt>
                <c:pt idx="1">
                  <c:v>4.2857142857142856</c:v>
                </c:pt>
                <c:pt idx="2">
                  <c:v>3.8571428571428572</c:v>
                </c:pt>
                <c:pt idx="3">
                  <c:v>2.785714285714286</c:v>
                </c:pt>
                <c:pt idx="4">
                  <c:v>3</c:v>
                </c:pt>
                <c:pt idx="5">
                  <c:v>2.9285714285714302</c:v>
                </c:pt>
                <c:pt idx="6">
                  <c:v>2.5714285714285712</c:v>
                </c:pt>
                <c:pt idx="7">
                  <c:v>2.57142857142857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00E-4A2A-8DC8-4DB1CDB536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80943736"/>
        <c:axId val="-2064199576"/>
      </c:lineChart>
      <c:catAx>
        <c:axId val="2080943736"/>
        <c:scaling>
          <c:orientation val="minMax"/>
        </c:scaling>
        <c:delete val="0"/>
        <c:axPos val="t"/>
        <c:numFmt formatCode="h:mm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064199576"/>
        <c:crosses val="autoZero"/>
        <c:auto val="1"/>
        <c:lblAlgn val="ctr"/>
        <c:lblOffset val="100"/>
        <c:noMultiLvlLbl val="0"/>
      </c:catAx>
      <c:valAx>
        <c:axId val="-2064199576"/>
        <c:scaling>
          <c:orientation val="maxMin"/>
          <c:min val="2"/>
        </c:scaling>
        <c:delete val="0"/>
        <c:axPos val="l"/>
        <c:majorGridlines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2080943736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81139032599999"/>
          <c:y val="8.28336187089979E-2"/>
          <c:w val="0.80075449574671898"/>
          <c:h val="0.831043805684411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ED1-42E1-829B-EE323F2712E2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accent3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5ED1-42E1-829B-EE323F2712E2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ED1-42E1-829B-EE323F2712E2}"/>
              </c:ext>
            </c:extLst>
          </c:dPt>
          <c:errBars>
            <c:errBarType val="both"/>
            <c:errValType val="stdErr"/>
            <c:noEndCap val="0"/>
          </c:errBars>
          <c:cat>
            <c:strRef>
              <c:f>(Sheet1!$D$15,Sheet1!$F$15,Sheet1!$H$15,Sheet1!$J$15)</c:f>
              <c:strCache>
                <c:ptCount val="4"/>
                <c:pt idx="0">
                  <c:v>Zolpidem</c:v>
                </c:pt>
                <c:pt idx="1">
                  <c:v>Suvorexanｔ</c:v>
                </c:pt>
                <c:pt idx="2">
                  <c:v>Ramelteon</c:v>
                </c:pt>
                <c:pt idx="3">
                  <c:v>Placebo</c:v>
                </c:pt>
              </c:strCache>
            </c:strRef>
          </c:cat>
          <c:val>
            <c:numRef>
              <c:f>(Sheet1!$D$23,Sheet1!$F$23,Sheet1!$H$23,Sheet1!$J$23)</c:f>
              <c:numCache>
                <c:formatCode>0.0</c:formatCode>
                <c:ptCount val="4"/>
                <c:pt idx="0">
                  <c:v>17.107142857142851</c:v>
                </c:pt>
                <c:pt idx="1">
                  <c:v>30.46153846153846</c:v>
                </c:pt>
                <c:pt idx="2">
                  <c:v>23.5</c:v>
                </c:pt>
                <c:pt idx="3">
                  <c:v>20.2857142857140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D1-42E1-829B-EE323F2712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35530648"/>
        <c:axId val="-2135103384"/>
      </c:barChart>
      <c:catAx>
        <c:axId val="-2135530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35103384"/>
        <c:crosses val="autoZero"/>
        <c:auto val="1"/>
        <c:lblAlgn val="ctr"/>
        <c:lblOffset val="100"/>
        <c:noMultiLvlLbl val="0"/>
      </c:catAx>
      <c:valAx>
        <c:axId val="-21351033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355306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>
        <a:lumMod val="95000"/>
      </a:schemeClr>
    </a:solidFill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4!$V$22</c:f>
              <c:strCache>
                <c:ptCount val="1"/>
                <c:pt idx="0">
                  <c:v>Zolpidem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Z$12:$AD$12</c:f>
                <c:numCache>
                  <c:formatCode>General</c:formatCode>
                  <c:ptCount val="5"/>
                  <c:pt idx="0">
                    <c:v>0.90732238424288603</c:v>
                  </c:pt>
                  <c:pt idx="1">
                    <c:v>0.90956024705025895</c:v>
                  </c:pt>
                  <c:pt idx="2">
                    <c:v>1.544748535418174</c:v>
                  </c:pt>
                  <c:pt idx="3">
                    <c:v>1.301709116816713</c:v>
                  </c:pt>
                  <c:pt idx="4">
                    <c:v>1.2447582403515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4!$W$21:$AA$21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4!$W$22:$AA$22</c:f>
              <c:numCache>
                <c:formatCode>General</c:formatCode>
                <c:ptCount val="5"/>
                <c:pt idx="0">
                  <c:v>40.771428571428523</c:v>
                </c:pt>
                <c:pt idx="1">
                  <c:v>43.128571428571462</c:v>
                </c:pt>
                <c:pt idx="2">
                  <c:v>42.585714285714253</c:v>
                </c:pt>
                <c:pt idx="3">
                  <c:v>42.392857142857153</c:v>
                </c:pt>
                <c:pt idx="4">
                  <c:v>41.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733-4E05-A2E3-D2374489FF97}"/>
            </c:ext>
          </c:extLst>
        </c:ser>
        <c:ser>
          <c:idx val="1"/>
          <c:order val="1"/>
          <c:tx>
            <c:strRef>
              <c:f>Sheet4!$V$23</c:f>
              <c:strCache>
                <c:ptCount val="1"/>
                <c:pt idx="0">
                  <c:v>Suvorexanｔ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Sheet4!$Z$13:$AD$13</c:f>
                <c:numCache>
                  <c:formatCode>General</c:formatCode>
                  <c:ptCount val="5"/>
                  <c:pt idx="0">
                    <c:v>1.240410627305639</c:v>
                  </c:pt>
                  <c:pt idx="1">
                    <c:v>1.126087473702706</c:v>
                  </c:pt>
                  <c:pt idx="2">
                    <c:v>1.3736774715770601</c:v>
                  </c:pt>
                  <c:pt idx="3">
                    <c:v>1.347544135170462</c:v>
                  </c:pt>
                  <c:pt idx="4">
                    <c:v>1.40683602389056</c:v>
                  </c:pt>
                </c:numCache>
              </c:numRef>
            </c:minus>
          </c:errBars>
          <c:cat>
            <c:numRef>
              <c:f>Sheet4!$W$21:$AA$21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4!$W$23:$AA$23</c:f>
              <c:numCache>
                <c:formatCode>General</c:formatCode>
                <c:ptCount val="5"/>
                <c:pt idx="0">
                  <c:v>41.028571428571432</c:v>
                </c:pt>
                <c:pt idx="1">
                  <c:v>41.907142857142823</c:v>
                </c:pt>
                <c:pt idx="2">
                  <c:v>42.535714285714278</c:v>
                </c:pt>
                <c:pt idx="3">
                  <c:v>42.007142857142853</c:v>
                </c:pt>
                <c:pt idx="4">
                  <c:v>42.235714285714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733-4E05-A2E3-D2374489FF97}"/>
            </c:ext>
          </c:extLst>
        </c:ser>
        <c:ser>
          <c:idx val="2"/>
          <c:order val="2"/>
          <c:tx>
            <c:strRef>
              <c:f>Sheet4!$V$24</c:f>
              <c:strCache>
                <c:ptCount val="1"/>
                <c:pt idx="0">
                  <c:v>Ramelteon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4!$Z$14:$AD$14</c:f>
                <c:numCache>
                  <c:formatCode>General</c:formatCode>
                  <c:ptCount val="5"/>
                  <c:pt idx="0">
                    <c:v>1.5524831985025409</c:v>
                  </c:pt>
                  <c:pt idx="1">
                    <c:v>1.4578268164249071</c:v>
                  </c:pt>
                  <c:pt idx="2">
                    <c:v>1.609064784881761</c:v>
                  </c:pt>
                  <c:pt idx="3">
                    <c:v>1.2356364709031671</c:v>
                  </c:pt>
                  <c:pt idx="4">
                    <c:v>1.35989310688981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4!$W$21:$AA$21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4!$W$24:$AA$24</c:f>
              <c:numCache>
                <c:formatCode>General</c:formatCode>
                <c:ptCount val="5"/>
                <c:pt idx="0">
                  <c:v>41.914285714285278</c:v>
                </c:pt>
                <c:pt idx="1">
                  <c:v>42.214285714285722</c:v>
                </c:pt>
                <c:pt idx="2">
                  <c:v>42.742857142857147</c:v>
                </c:pt>
                <c:pt idx="3">
                  <c:v>42.685714285714297</c:v>
                </c:pt>
                <c:pt idx="4">
                  <c:v>41.8428571428571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733-4E05-A2E3-D2374489FF97}"/>
            </c:ext>
          </c:extLst>
        </c:ser>
        <c:ser>
          <c:idx val="3"/>
          <c:order val="3"/>
          <c:tx>
            <c:strRef>
              <c:f>Sheet4!$V$25</c:f>
              <c:strCache>
                <c:ptCount val="1"/>
                <c:pt idx="0">
                  <c:v>Placebo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Sheet4!$Z$15:$AD$15</c:f>
                <c:numCache>
                  <c:formatCode>General</c:formatCode>
                  <c:ptCount val="5"/>
                  <c:pt idx="0">
                    <c:v>1.436718526917756</c:v>
                  </c:pt>
                  <c:pt idx="1">
                    <c:v>1.5587311689778001</c:v>
                  </c:pt>
                  <c:pt idx="2">
                    <c:v>1.478803665999832</c:v>
                  </c:pt>
                  <c:pt idx="3">
                    <c:v>1.2937553797884409</c:v>
                  </c:pt>
                  <c:pt idx="4">
                    <c:v>1.3536116581919251</c:v>
                  </c:pt>
                </c:numCache>
              </c:numRef>
            </c:minus>
          </c:errBars>
          <c:cat>
            <c:numRef>
              <c:f>Sheet4!$W$21:$AA$21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4!$W$25:$AA$25</c:f>
              <c:numCache>
                <c:formatCode>General</c:formatCode>
                <c:ptCount val="5"/>
                <c:pt idx="0">
                  <c:v>41.485714285714273</c:v>
                </c:pt>
                <c:pt idx="1">
                  <c:v>41.05</c:v>
                </c:pt>
                <c:pt idx="2">
                  <c:v>41.371428571428119</c:v>
                </c:pt>
                <c:pt idx="3">
                  <c:v>40.935714285714297</c:v>
                </c:pt>
                <c:pt idx="4">
                  <c:v>41.9357142857142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733-4E05-A2E3-D2374489FF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029436328"/>
        <c:axId val="-2029439128"/>
      </c:lineChart>
      <c:catAx>
        <c:axId val="-2029436328"/>
        <c:scaling>
          <c:orientation val="minMax"/>
        </c:scaling>
        <c:delete val="0"/>
        <c:axPos val="b"/>
        <c:numFmt formatCode="h:mm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029439128"/>
        <c:crosses val="autoZero"/>
        <c:auto val="1"/>
        <c:lblAlgn val="ctr"/>
        <c:lblOffset val="100"/>
        <c:noMultiLvlLbl val="0"/>
      </c:catAx>
      <c:valAx>
        <c:axId val="-2029439128"/>
        <c:scaling>
          <c:orientation val="minMax"/>
          <c:min val="40.5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ja-JP"/>
                </a:pPr>
                <a:r>
                  <a:rPr lang="ja-JP" altLang="en-US"/>
                  <a:t>ｃｍ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029436328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3!$Z$3</c:f>
              <c:strCache>
                <c:ptCount val="1"/>
                <c:pt idx="0">
                  <c:v>Zolpidem</c:v>
                </c:pt>
              </c:strCache>
            </c:strRef>
          </c:tx>
          <c:spPr>
            <a:ln w="28575" cap="rnd" cmpd="sng" algn="ctr">
              <a:solidFill>
                <a:schemeClr val="accent1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3!$AA$8:$AE$8</c:f>
                <c:numCache>
                  <c:formatCode>General</c:formatCode>
                  <c:ptCount val="5"/>
                  <c:pt idx="0">
                    <c:v>0.234454257922702</c:v>
                  </c:pt>
                  <c:pt idx="1">
                    <c:v>0.20780766753803401</c:v>
                  </c:pt>
                  <c:pt idx="2">
                    <c:v>0.19719301798549899</c:v>
                  </c:pt>
                  <c:pt idx="3">
                    <c:v>0.19404164129312601</c:v>
                  </c:pt>
                  <c:pt idx="4">
                    <c:v>0.19549769438188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3!$AA$2:$AE$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3!$AA$3:$AE$3</c:f>
              <c:numCache>
                <c:formatCode>General</c:formatCode>
                <c:ptCount val="5"/>
                <c:pt idx="0">
                  <c:v>4.7135714285714281</c:v>
                </c:pt>
                <c:pt idx="1">
                  <c:v>4.8292857142857146</c:v>
                </c:pt>
                <c:pt idx="2">
                  <c:v>4.6171428571428237</c:v>
                </c:pt>
                <c:pt idx="3">
                  <c:v>4.5707142857142857</c:v>
                </c:pt>
                <c:pt idx="4">
                  <c:v>4.57642857142857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AA0-4ECA-A95B-67A59D8EB153}"/>
            </c:ext>
          </c:extLst>
        </c:ser>
        <c:ser>
          <c:idx val="1"/>
          <c:order val="1"/>
          <c:tx>
            <c:strRef>
              <c:f>Sheet3!$Z$4</c:f>
              <c:strCache>
                <c:ptCount val="1"/>
                <c:pt idx="0">
                  <c:v>Suvorexanｔ</c:v>
                </c:pt>
              </c:strCache>
            </c:strRef>
          </c:tx>
          <c:spPr>
            <a:ln w="28575" cap="rnd" cmpd="sng" algn="ctr">
              <a:solidFill>
                <a:schemeClr val="accent2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3!$AA$9:$AE$9</c:f>
                <c:numCache>
                  <c:formatCode>General</c:formatCode>
                  <c:ptCount val="5"/>
                  <c:pt idx="0">
                    <c:v>0.17770470982292499</c:v>
                  </c:pt>
                  <c:pt idx="1">
                    <c:v>0.18809098386249501</c:v>
                  </c:pt>
                  <c:pt idx="2">
                    <c:v>0.174584166186977</c:v>
                  </c:pt>
                  <c:pt idx="3">
                    <c:v>0.175980322148131</c:v>
                  </c:pt>
                  <c:pt idx="4">
                    <c:v>0.174008178410800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3!$AA$2:$AE$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3!$AA$4:$AE$4</c:f>
              <c:numCache>
                <c:formatCode>General</c:formatCode>
                <c:ptCount val="5"/>
                <c:pt idx="0">
                  <c:v>4.7114285714285709</c:v>
                </c:pt>
                <c:pt idx="1">
                  <c:v>4.7678571428571397</c:v>
                </c:pt>
                <c:pt idx="2">
                  <c:v>4.6707142857142854</c:v>
                </c:pt>
                <c:pt idx="3">
                  <c:v>4.6085714285714277</c:v>
                </c:pt>
                <c:pt idx="4">
                  <c:v>4.60499999999997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AA0-4ECA-A95B-67A59D8EB153}"/>
            </c:ext>
          </c:extLst>
        </c:ser>
        <c:ser>
          <c:idx val="2"/>
          <c:order val="2"/>
          <c:tx>
            <c:strRef>
              <c:f>Sheet3!$Z$5</c:f>
              <c:strCache>
                <c:ptCount val="1"/>
                <c:pt idx="0">
                  <c:v>Ramelteon</c:v>
                </c:pt>
              </c:strCache>
            </c:strRef>
          </c:tx>
          <c:spPr>
            <a:ln w="28575" cap="rnd" cmpd="sng" algn="ctr">
              <a:solidFill>
                <a:schemeClr val="accent3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Ref>
                <c:f>Sheet3!$AA$10:$AE$10</c:f>
                <c:numCache>
                  <c:formatCode>General</c:formatCode>
                  <c:ptCount val="5"/>
                  <c:pt idx="0">
                    <c:v>0.15578131433644199</c:v>
                  </c:pt>
                  <c:pt idx="1">
                    <c:v>0.222013053486428</c:v>
                  </c:pt>
                  <c:pt idx="2">
                    <c:v>0.19884448377667899</c:v>
                  </c:pt>
                  <c:pt idx="3">
                    <c:v>0.18678442732731601</c:v>
                  </c:pt>
                  <c:pt idx="4">
                    <c:v>0.20631028209004901</c:v>
                  </c:pt>
                </c:numCache>
              </c:numRef>
            </c:plus>
            <c:minus>
              <c:numRef>
                <c:f>Sheet3!$AA$10:$AE$10</c:f>
                <c:numCache>
                  <c:formatCode>General</c:formatCode>
                  <c:ptCount val="5"/>
                  <c:pt idx="0">
                    <c:v>0.15578131433644199</c:v>
                  </c:pt>
                  <c:pt idx="1">
                    <c:v>0.222013053486428</c:v>
                  </c:pt>
                  <c:pt idx="2">
                    <c:v>0.19884448377667899</c:v>
                  </c:pt>
                  <c:pt idx="3">
                    <c:v>0.18678442732731601</c:v>
                  </c:pt>
                  <c:pt idx="4">
                    <c:v>0.20631028209004901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3!$AA$2:$AE$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3!$AA$5:$AE$5</c:f>
              <c:numCache>
                <c:formatCode>General</c:formatCode>
                <c:ptCount val="5"/>
                <c:pt idx="0">
                  <c:v>4.6642857142856746</c:v>
                </c:pt>
                <c:pt idx="1">
                  <c:v>4.7457142857142864</c:v>
                </c:pt>
                <c:pt idx="2">
                  <c:v>4.6935714285714276</c:v>
                </c:pt>
                <c:pt idx="3">
                  <c:v>4.4192857142857154</c:v>
                </c:pt>
                <c:pt idx="4">
                  <c:v>4.69214285714283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AA0-4ECA-A95B-67A59D8EB153}"/>
            </c:ext>
          </c:extLst>
        </c:ser>
        <c:ser>
          <c:idx val="3"/>
          <c:order val="3"/>
          <c:tx>
            <c:strRef>
              <c:f>Sheet3!$Z$6</c:f>
              <c:strCache>
                <c:ptCount val="1"/>
                <c:pt idx="0">
                  <c:v>Placebo</c:v>
                </c:pt>
              </c:strCache>
            </c:strRef>
          </c:tx>
          <c:spPr>
            <a:ln w="28575" cap="rnd" cmpd="sng" algn="ctr">
              <a:solidFill>
                <a:schemeClr val="accent4"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Sheet3!$AA$11:$AE$11</c:f>
                <c:numCache>
                  <c:formatCode>General</c:formatCode>
                  <c:ptCount val="5"/>
                  <c:pt idx="0">
                    <c:v>0.18923553139468699</c:v>
                  </c:pt>
                  <c:pt idx="1">
                    <c:v>0.225748102210167</c:v>
                  </c:pt>
                  <c:pt idx="2">
                    <c:v>0.171393311392111</c:v>
                  </c:pt>
                  <c:pt idx="3">
                    <c:v>0.19173063342298499</c:v>
                  </c:pt>
                  <c:pt idx="4">
                    <c:v>0.182340121578347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Sheet3!$AA$2:$AE$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3!$AA$6:$AE$6</c:f>
              <c:numCache>
                <c:formatCode>General</c:formatCode>
                <c:ptCount val="5"/>
                <c:pt idx="0">
                  <c:v>4.6278571428571347</c:v>
                </c:pt>
                <c:pt idx="1">
                  <c:v>4.7264285714285696</c:v>
                </c:pt>
                <c:pt idx="2">
                  <c:v>4.5714285714285712</c:v>
                </c:pt>
                <c:pt idx="3">
                  <c:v>4.5521428571428446</c:v>
                </c:pt>
                <c:pt idx="4">
                  <c:v>4.60642857142856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AA0-4ECA-A95B-67A59D8EB1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029287736"/>
        <c:axId val="-2029284456"/>
      </c:lineChart>
      <c:catAx>
        <c:axId val="-2029287736"/>
        <c:scaling>
          <c:orientation val="minMax"/>
        </c:scaling>
        <c:delete val="0"/>
        <c:axPos val="t"/>
        <c:numFmt formatCode="h:mm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029284456"/>
        <c:crosses val="autoZero"/>
        <c:auto val="1"/>
        <c:lblAlgn val="ctr"/>
        <c:lblOffset val="100"/>
        <c:noMultiLvlLbl val="0"/>
      </c:catAx>
      <c:valAx>
        <c:axId val="-2029284456"/>
        <c:scaling>
          <c:orientation val="maxMin"/>
          <c:min val="4.4000000000000004"/>
        </c:scaling>
        <c:delete val="0"/>
        <c:axPos val="l"/>
        <c:majorGridlines>
          <c:spPr>
            <a:ln w="9525" cap="flat" cmpd="sng" algn="ctr">
              <a:solidFill>
                <a:schemeClr val="tx1">
                  <a:tint val="75000"/>
                  <a:shade val="95000"/>
                  <a:satMod val="105000"/>
                </a:schemeClr>
              </a:solidFill>
              <a:prstDash val="solid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sec</a:t>
                </a:r>
                <a:endParaRPr lang="ja-JP" altLang="en-US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0292877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開眼!$R$23</c:f>
              <c:strCache>
                <c:ptCount val="1"/>
                <c:pt idx="0">
                  <c:v>Zolpidem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開眼!$Y$13:$AC$13</c:f>
                <c:numCache>
                  <c:formatCode>General</c:formatCode>
                  <c:ptCount val="5"/>
                  <c:pt idx="0">
                    <c:v>2.7459802846769432</c:v>
                  </c:pt>
                  <c:pt idx="1">
                    <c:v>2.992518593090816</c:v>
                  </c:pt>
                  <c:pt idx="2">
                    <c:v>1.884645479992942</c:v>
                  </c:pt>
                  <c:pt idx="3">
                    <c:v>2.1748862228617578</c:v>
                  </c:pt>
                  <c:pt idx="4">
                    <c:v>2.028966665859989</c:v>
                  </c:pt>
                </c:numCache>
              </c:numRef>
            </c:minus>
          </c:errBars>
          <c:cat>
            <c:numRef>
              <c:f>開眼!$S$22:$W$2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開眼!$S$23:$W$23</c:f>
              <c:numCache>
                <c:formatCode>General</c:formatCode>
                <c:ptCount val="5"/>
                <c:pt idx="0">
                  <c:v>43.226963230714297</c:v>
                </c:pt>
                <c:pt idx="1">
                  <c:v>44.988531210714278</c:v>
                </c:pt>
                <c:pt idx="2">
                  <c:v>40.096303185714298</c:v>
                </c:pt>
                <c:pt idx="3">
                  <c:v>42.517079542857147</c:v>
                </c:pt>
                <c:pt idx="4">
                  <c:v>41.8005309592857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CF4-4E00-B75B-AE179DA35B0C}"/>
            </c:ext>
          </c:extLst>
        </c:ser>
        <c:ser>
          <c:idx val="1"/>
          <c:order val="1"/>
          <c:tx>
            <c:strRef>
              <c:f>開眼!$R$24</c:f>
              <c:strCache>
                <c:ptCount val="1"/>
                <c:pt idx="0">
                  <c:v>Suvorexanｔ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開眼!$Y$14:$AC$14</c:f>
                <c:numCache>
                  <c:formatCode>General</c:formatCode>
                  <c:ptCount val="5"/>
                  <c:pt idx="0">
                    <c:v>3.287854672139952</c:v>
                  </c:pt>
                  <c:pt idx="1">
                    <c:v>2.93085753535938</c:v>
                  </c:pt>
                  <c:pt idx="2">
                    <c:v>2.8389851663274381</c:v>
                  </c:pt>
                  <c:pt idx="3">
                    <c:v>3.3685987676545519</c:v>
                  </c:pt>
                  <c:pt idx="4">
                    <c:v>2.7424985633953849</c:v>
                  </c:pt>
                </c:numCache>
              </c:numRef>
            </c:minus>
          </c:errBars>
          <c:cat>
            <c:numRef>
              <c:f>開眼!$S$22:$W$2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開眼!$S$24:$W$24</c:f>
              <c:numCache>
                <c:formatCode>General</c:formatCode>
                <c:ptCount val="5"/>
                <c:pt idx="0">
                  <c:v>46.905539097857151</c:v>
                </c:pt>
                <c:pt idx="1">
                  <c:v>46.931790434285709</c:v>
                </c:pt>
                <c:pt idx="2">
                  <c:v>43.518305960714301</c:v>
                </c:pt>
                <c:pt idx="3">
                  <c:v>46.101135397142862</c:v>
                </c:pt>
                <c:pt idx="4">
                  <c:v>45.396499505713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CF4-4E00-B75B-AE179DA35B0C}"/>
            </c:ext>
          </c:extLst>
        </c:ser>
        <c:ser>
          <c:idx val="2"/>
          <c:order val="2"/>
          <c:tx>
            <c:strRef>
              <c:f>開眼!$R$25</c:f>
              <c:strCache>
                <c:ptCount val="1"/>
                <c:pt idx="0">
                  <c:v>Ramelteon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開眼!$Y$15:$AC$15</c:f>
                <c:numCache>
                  <c:formatCode>General</c:formatCode>
                  <c:ptCount val="5"/>
                  <c:pt idx="0">
                    <c:v>2.9489609698521599</c:v>
                  </c:pt>
                  <c:pt idx="1">
                    <c:v>3.4827933488881482</c:v>
                  </c:pt>
                  <c:pt idx="2">
                    <c:v>3.8901395252138591</c:v>
                  </c:pt>
                  <c:pt idx="3">
                    <c:v>3.372385055823202</c:v>
                  </c:pt>
                  <c:pt idx="4">
                    <c:v>3.42943037529242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開眼!$S$22:$W$2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開眼!$S$25:$W$25</c:f>
              <c:numCache>
                <c:formatCode>General</c:formatCode>
                <c:ptCount val="5"/>
                <c:pt idx="0">
                  <c:v>45.264090884285721</c:v>
                </c:pt>
                <c:pt idx="1">
                  <c:v>47.734636946428573</c:v>
                </c:pt>
                <c:pt idx="2">
                  <c:v>47.563943252142863</c:v>
                </c:pt>
                <c:pt idx="3">
                  <c:v>45.828521457142273</c:v>
                </c:pt>
                <c:pt idx="4">
                  <c:v>46.5673725235714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CF4-4E00-B75B-AE179DA35B0C}"/>
            </c:ext>
          </c:extLst>
        </c:ser>
        <c:ser>
          <c:idx val="3"/>
          <c:order val="3"/>
          <c:tx>
            <c:strRef>
              <c:f>開眼!$R$26</c:f>
              <c:strCache>
                <c:ptCount val="1"/>
                <c:pt idx="0">
                  <c:v>Placebo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開眼!$Y$16:$AC$16</c:f>
                <c:numCache>
                  <c:formatCode>General</c:formatCode>
                  <c:ptCount val="5"/>
                  <c:pt idx="0">
                    <c:v>2.7765592145713578</c:v>
                  </c:pt>
                  <c:pt idx="1">
                    <c:v>4.3126983295658556</c:v>
                  </c:pt>
                  <c:pt idx="2">
                    <c:v>3.390666800650552</c:v>
                  </c:pt>
                  <c:pt idx="3">
                    <c:v>2.695132450572804</c:v>
                  </c:pt>
                  <c:pt idx="4">
                    <c:v>3.49037727781421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開眼!$S$22:$W$2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開眼!$S$26:$W$26</c:f>
              <c:numCache>
                <c:formatCode>General</c:formatCode>
                <c:ptCount val="5"/>
                <c:pt idx="0">
                  <c:v>44.654078855713827</c:v>
                </c:pt>
                <c:pt idx="1">
                  <c:v>49.292846817142852</c:v>
                </c:pt>
                <c:pt idx="2">
                  <c:v>44.415027454999993</c:v>
                </c:pt>
                <c:pt idx="3">
                  <c:v>43.002750913571433</c:v>
                </c:pt>
                <c:pt idx="4">
                  <c:v>46.398233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CF4-4E00-B75B-AE179DA35B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1919621976"/>
        <c:axId val="1729155224"/>
      </c:lineChart>
      <c:catAx>
        <c:axId val="-1919621976"/>
        <c:scaling>
          <c:orientation val="minMax"/>
        </c:scaling>
        <c:delete val="0"/>
        <c:axPos val="t"/>
        <c:numFmt formatCode="h:mm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1729155224"/>
        <c:crosses val="autoZero"/>
        <c:auto val="1"/>
        <c:lblAlgn val="ctr"/>
        <c:lblOffset val="100"/>
        <c:noMultiLvlLbl val="0"/>
      </c:catAx>
      <c:valAx>
        <c:axId val="1729155224"/>
        <c:scaling>
          <c:orientation val="maxMin"/>
          <c:min val="39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ja-JP"/>
                </a:pPr>
                <a:r>
                  <a:rPr lang="ja-JP" altLang="en-US"/>
                  <a:t>ｃｍ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1919621976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2!$X$22</c:f>
              <c:strCache>
                <c:ptCount val="1"/>
                <c:pt idx="0">
                  <c:v>Zolpidem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2!$AA$10:$AE$10</c:f>
                <c:numCache>
                  <c:formatCode>General</c:formatCode>
                  <c:ptCount val="5"/>
                  <c:pt idx="0">
                    <c:v>0.59623771375432399</c:v>
                  </c:pt>
                  <c:pt idx="1">
                    <c:v>0.55646619940765696</c:v>
                  </c:pt>
                  <c:pt idx="2">
                    <c:v>0.60643543143196599</c:v>
                  </c:pt>
                  <c:pt idx="3">
                    <c:v>0.52575448514484602</c:v>
                  </c:pt>
                  <c:pt idx="4">
                    <c:v>0.436735427455772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2!$Y$21:$AC$21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2!$Y$22:$AC$22</c:f>
              <c:numCache>
                <c:formatCode>General</c:formatCode>
                <c:ptCount val="5"/>
                <c:pt idx="0">
                  <c:v>33.589285714285722</c:v>
                </c:pt>
                <c:pt idx="1">
                  <c:v>31.964285714285719</c:v>
                </c:pt>
                <c:pt idx="2">
                  <c:v>32.232142857142861</c:v>
                </c:pt>
                <c:pt idx="3">
                  <c:v>32.732142857142861</c:v>
                </c:pt>
                <c:pt idx="4">
                  <c:v>33.1071428571428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1E1-4105-9C98-30C7E7FEFAE4}"/>
            </c:ext>
          </c:extLst>
        </c:ser>
        <c:ser>
          <c:idx val="1"/>
          <c:order val="1"/>
          <c:tx>
            <c:strRef>
              <c:f>Sheet2!$X$23</c:f>
              <c:strCache>
                <c:ptCount val="1"/>
                <c:pt idx="0">
                  <c:v>Suvorexanｔ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2!$AA$11:$AE$11</c:f>
                <c:numCache>
                  <c:formatCode>General</c:formatCode>
                  <c:ptCount val="5"/>
                  <c:pt idx="0">
                    <c:v>0.67256231729382698</c:v>
                  </c:pt>
                  <c:pt idx="1">
                    <c:v>0.64592142087611903</c:v>
                  </c:pt>
                  <c:pt idx="2">
                    <c:v>0.83305201949815399</c:v>
                  </c:pt>
                  <c:pt idx="3">
                    <c:v>0.64071682776028005</c:v>
                  </c:pt>
                  <c:pt idx="4">
                    <c:v>0.515364405986301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2!$Y$21:$AC$21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2!$Y$23:$AC$23</c:f>
              <c:numCache>
                <c:formatCode>General</c:formatCode>
                <c:ptCount val="5"/>
                <c:pt idx="0">
                  <c:v>33.839285714285722</c:v>
                </c:pt>
                <c:pt idx="1">
                  <c:v>31.732142857142779</c:v>
                </c:pt>
                <c:pt idx="2">
                  <c:v>32.428571428571431</c:v>
                </c:pt>
                <c:pt idx="3">
                  <c:v>32.857142857142257</c:v>
                </c:pt>
                <c:pt idx="4">
                  <c:v>32.6428571428571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1E1-4105-9C98-30C7E7FEFAE4}"/>
            </c:ext>
          </c:extLst>
        </c:ser>
        <c:ser>
          <c:idx val="2"/>
          <c:order val="2"/>
          <c:tx>
            <c:strRef>
              <c:f>Sheet2!$X$24</c:f>
              <c:strCache>
                <c:ptCount val="1"/>
                <c:pt idx="0">
                  <c:v>Ramelteon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Sheet2!$AA$12:$AE$12</c:f>
                <c:numCache>
                  <c:formatCode>General</c:formatCode>
                  <c:ptCount val="5"/>
                  <c:pt idx="0">
                    <c:v>0.44101108498547198</c:v>
                  </c:pt>
                  <c:pt idx="1">
                    <c:v>0.58180820287218105</c:v>
                  </c:pt>
                  <c:pt idx="2">
                    <c:v>0.49921445356043298</c:v>
                  </c:pt>
                  <c:pt idx="3">
                    <c:v>0.45044893008922199</c:v>
                  </c:pt>
                  <c:pt idx="4">
                    <c:v>0.50127388741493595</c:v>
                  </c:pt>
                </c:numCache>
              </c:numRef>
            </c:minus>
          </c:errBars>
          <c:cat>
            <c:numRef>
              <c:f>Sheet2!$Y$21:$AC$21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2!$Y$24:$AC$24</c:f>
              <c:numCache>
                <c:formatCode>General</c:formatCode>
                <c:ptCount val="5"/>
                <c:pt idx="0">
                  <c:v>32.946428571428292</c:v>
                </c:pt>
                <c:pt idx="1">
                  <c:v>31.964285714285719</c:v>
                </c:pt>
                <c:pt idx="2">
                  <c:v>31.464285714285719</c:v>
                </c:pt>
                <c:pt idx="3">
                  <c:v>32.178571428571431</c:v>
                </c:pt>
                <c:pt idx="4">
                  <c:v>32.5357142857142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1E1-4105-9C98-30C7E7FEFAE4}"/>
            </c:ext>
          </c:extLst>
        </c:ser>
        <c:ser>
          <c:idx val="3"/>
          <c:order val="3"/>
          <c:tx>
            <c:strRef>
              <c:f>Sheet2!$X$25</c:f>
              <c:strCache>
                <c:ptCount val="1"/>
                <c:pt idx="0">
                  <c:v>Placebo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Sheet2!$AA$13:$AE$13</c:f>
                <c:numCache>
                  <c:formatCode>General</c:formatCode>
                  <c:ptCount val="5"/>
                  <c:pt idx="0">
                    <c:v>0.65474733583525102</c:v>
                  </c:pt>
                  <c:pt idx="1">
                    <c:v>0.55531893617912997</c:v>
                  </c:pt>
                  <c:pt idx="2">
                    <c:v>0.55374864231860799</c:v>
                  </c:pt>
                  <c:pt idx="3">
                    <c:v>0.54508741539670702</c:v>
                  </c:pt>
                  <c:pt idx="4">
                    <c:v>0.54256155197047395</c:v>
                  </c:pt>
                </c:numCache>
              </c:numRef>
            </c:minus>
          </c:errBars>
          <c:cat>
            <c:numRef>
              <c:f>Sheet2!$Y$21:$AC$21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Sheet2!$Y$25:$AC$25</c:f>
              <c:numCache>
                <c:formatCode>General</c:formatCode>
                <c:ptCount val="5"/>
                <c:pt idx="0">
                  <c:v>33.196428571428562</c:v>
                </c:pt>
                <c:pt idx="1">
                  <c:v>32</c:v>
                </c:pt>
                <c:pt idx="2">
                  <c:v>32.232142857142861</c:v>
                </c:pt>
                <c:pt idx="3">
                  <c:v>32.910714285714192</c:v>
                </c:pt>
                <c:pt idx="4">
                  <c:v>32.8392857142857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1E1-4105-9C98-30C7E7FEFA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105536648"/>
        <c:axId val="-2071760984"/>
      </c:lineChart>
      <c:catAx>
        <c:axId val="-2105536648"/>
        <c:scaling>
          <c:orientation val="minMax"/>
        </c:scaling>
        <c:delete val="0"/>
        <c:axPos val="b"/>
        <c:numFmt formatCode="h:mm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071760984"/>
        <c:crosses val="autoZero"/>
        <c:auto val="1"/>
        <c:lblAlgn val="ctr"/>
        <c:lblOffset val="100"/>
        <c:noMultiLvlLbl val="0"/>
      </c:catAx>
      <c:valAx>
        <c:axId val="-2071760984"/>
        <c:scaling>
          <c:orientation val="minMax"/>
          <c:max val="34"/>
          <c:min val="31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ja-JP"/>
                </a:pPr>
                <a:r>
                  <a:rPr lang="en-US" altLang="ja-JP"/>
                  <a:t>Hz</a:t>
                </a:r>
                <a:endParaRPr lang="ja-JP" altLang="en-US"/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105536648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手の正答率!$Y$3</c:f>
              <c:strCache>
                <c:ptCount val="1"/>
                <c:pt idx="0">
                  <c:v>Zolpidem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手の正答率!$AF$3:$AJ$3</c:f>
                <c:numCache>
                  <c:formatCode>General</c:formatCode>
                  <c:ptCount val="5"/>
                  <c:pt idx="0">
                    <c:v>2.2381801869935649</c:v>
                  </c:pt>
                  <c:pt idx="1">
                    <c:v>2.320041851243801</c:v>
                  </c:pt>
                  <c:pt idx="2">
                    <c:v>2.3298520041125981</c:v>
                  </c:pt>
                  <c:pt idx="3">
                    <c:v>1.82484166320297</c:v>
                  </c:pt>
                  <c:pt idx="4">
                    <c:v>1.7708402514716961</c:v>
                  </c:pt>
                </c:numCache>
              </c:numRef>
            </c:minus>
          </c:errBars>
          <c:cat>
            <c:numRef>
              <c:f>手の正答率!$Z$2:$AD$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手の正答率!$Z$3:$AD$3</c:f>
              <c:numCache>
                <c:formatCode>General</c:formatCode>
                <c:ptCount val="5"/>
                <c:pt idx="0">
                  <c:v>92.600000000000009</c:v>
                </c:pt>
                <c:pt idx="1">
                  <c:v>92.235714285714295</c:v>
                </c:pt>
                <c:pt idx="2">
                  <c:v>92.042857142856263</c:v>
                </c:pt>
                <c:pt idx="3">
                  <c:v>92.471428571428447</c:v>
                </c:pt>
                <c:pt idx="4">
                  <c:v>93.807142857142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3B8-4154-B363-1C680AA0E6BF}"/>
            </c:ext>
          </c:extLst>
        </c:ser>
        <c:ser>
          <c:idx val="1"/>
          <c:order val="1"/>
          <c:tx>
            <c:strRef>
              <c:f>手の正答率!$Y$4</c:f>
              <c:strCache>
                <c:ptCount val="1"/>
                <c:pt idx="0">
                  <c:v>Suvorexanｔ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手の正答率!$AF$4:$AJ$4</c:f>
                <c:numCache>
                  <c:formatCode>General</c:formatCode>
                  <c:ptCount val="5"/>
                  <c:pt idx="0">
                    <c:v>1.2815867813686921</c:v>
                  </c:pt>
                  <c:pt idx="1">
                    <c:v>1.7950612518683551</c:v>
                  </c:pt>
                  <c:pt idx="2">
                    <c:v>1.86531696457625</c:v>
                  </c:pt>
                  <c:pt idx="3">
                    <c:v>2.496908606710877</c:v>
                  </c:pt>
                  <c:pt idx="4">
                    <c:v>2.00953379161800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手の正答率!$Z$2:$AD$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手の正答率!$Z$4:$AD$4</c:f>
              <c:numCache>
                <c:formatCode>General</c:formatCode>
                <c:ptCount val="5"/>
                <c:pt idx="0">
                  <c:v>94.728571428570845</c:v>
                </c:pt>
                <c:pt idx="1">
                  <c:v>91.728571428570845</c:v>
                </c:pt>
                <c:pt idx="2">
                  <c:v>94.264285714285705</c:v>
                </c:pt>
                <c:pt idx="3">
                  <c:v>90.271428571428245</c:v>
                </c:pt>
                <c:pt idx="4">
                  <c:v>92.5857142857143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3B8-4154-B363-1C680AA0E6BF}"/>
            </c:ext>
          </c:extLst>
        </c:ser>
        <c:ser>
          <c:idx val="2"/>
          <c:order val="2"/>
          <c:tx>
            <c:strRef>
              <c:f>手の正答率!$Y$5</c:f>
              <c:strCache>
                <c:ptCount val="1"/>
                <c:pt idx="0">
                  <c:v>Ramelteon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手の正答率!$AF$5:$AJ$5</c:f>
                <c:numCache>
                  <c:formatCode>General</c:formatCode>
                  <c:ptCount val="5"/>
                  <c:pt idx="0">
                    <c:v>2.514389514590611</c:v>
                  </c:pt>
                  <c:pt idx="1">
                    <c:v>2.5829055536161398</c:v>
                  </c:pt>
                  <c:pt idx="2">
                    <c:v>3.0518626733652572</c:v>
                  </c:pt>
                  <c:pt idx="3">
                    <c:v>1.738586914249254</c:v>
                  </c:pt>
                  <c:pt idx="4">
                    <c:v>2.81502542295233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手の正答率!$Z$2:$AD$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手の正答率!$Z$5:$AD$5</c:f>
              <c:numCache>
                <c:formatCode>General</c:formatCode>
                <c:ptCount val="5"/>
                <c:pt idx="0">
                  <c:v>91.835714285714303</c:v>
                </c:pt>
                <c:pt idx="1">
                  <c:v>93.15</c:v>
                </c:pt>
                <c:pt idx="2">
                  <c:v>92.978571428570845</c:v>
                </c:pt>
                <c:pt idx="3">
                  <c:v>94.228571428570845</c:v>
                </c:pt>
                <c:pt idx="4">
                  <c:v>91.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3B8-4154-B363-1C680AA0E6BF}"/>
            </c:ext>
          </c:extLst>
        </c:ser>
        <c:ser>
          <c:idx val="3"/>
          <c:order val="3"/>
          <c:tx>
            <c:strRef>
              <c:f>手の正答率!$Y$6</c:f>
              <c:strCache>
                <c:ptCount val="1"/>
                <c:pt idx="0">
                  <c:v>Placebo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手の正答率!$AF$6:$AJ$6</c:f>
                <c:numCache>
                  <c:formatCode>General</c:formatCode>
                  <c:ptCount val="5"/>
                  <c:pt idx="0">
                    <c:v>2.4295053149464851</c:v>
                  </c:pt>
                  <c:pt idx="1">
                    <c:v>2.8138484906085952</c:v>
                  </c:pt>
                  <c:pt idx="2">
                    <c:v>2.9797754964794261</c:v>
                  </c:pt>
                  <c:pt idx="3">
                    <c:v>2.3736121285693841</c:v>
                  </c:pt>
                  <c:pt idx="4">
                    <c:v>2.2243126396699031</c:v>
                  </c:pt>
                </c:numCache>
              </c:numRef>
            </c:minus>
          </c:errBars>
          <c:cat>
            <c:numRef>
              <c:f>手の正答率!$Z$2:$AD$2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手の正答率!$Z$6:$AD$6</c:f>
              <c:numCache>
                <c:formatCode>General</c:formatCode>
                <c:ptCount val="5"/>
                <c:pt idx="0">
                  <c:v>92.05714285714285</c:v>
                </c:pt>
                <c:pt idx="1">
                  <c:v>91.30714285714285</c:v>
                </c:pt>
                <c:pt idx="2">
                  <c:v>88.80714285714285</c:v>
                </c:pt>
                <c:pt idx="3">
                  <c:v>93.642857142856045</c:v>
                </c:pt>
                <c:pt idx="4">
                  <c:v>93.1857142857142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3B8-4154-B363-1C680AA0E6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138512136"/>
        <c:axId val="-2130807992"/>
      </c:lineChart>
      <c:catAx>
        <c:axId val="2138512136"/>
        <c:scaling>
          <c:orientation val="minMax"/>
        </c:scaling>
        <c:delete val="0"/>
        <c:axPos val="b"/>
        <c:numFmt formatCode="h:mm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130807992"/>
        <c:crosses val="autoZero"/>
        <c:auto val="1"/>
        <c:lblAlgn val="ctr"/>
        <c:lblOffset val="100"/>
        <c:noMultiLvlLbl val="0"/>
      </c:catAx>
      <c:valAx>
        <c:axId val="-2130807992"/>
        <c:scaling>
          <c:orientation val="minMax"/>
          <c:min val="87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ja-JP"/>
                </a:pPr>
                <a:r>
                  <a:rPr lang="ja-JP" altLang="en-US"/>
                  <a:t>％</a:t>
                </a:r>
              </a:p>
            </c:rich>
          </c:tx>
          <c:layout>
            <c:manualLayout>
              <c:xMode val="edge"/>
              <c:yMode val="edge"/>
              <c:x val="2.5000000000000001E-2"/>
              <c:y val="0.45082349081364798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2138512136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記憶正答率!$X$4</c:f>
              <c:strCache>
                <c:ptCount val="1"/>
                <c:pt idx="0">
                  <c:v>Zolpidem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記憶正答率!$AD$4:$AH$4</c:f>
                <c:numCache>
                  <c:formatCode>General</c:formatCode>
                  <c:ptCount val="5"/>
                  <c:pt idx="0">
                    <c:v>3.1252579171430872</c:v>
                  </c:pt>
                  <c:pt idx="1">
                    <c:v>3.4805385146049339</c:v>
                  </c:pt>
                  <c:pt idx="2">
                    <c:v>2.5900099403990389</c:v>
                  </c:pt>
                  <c:pt idx="3">
                    <c:v>3.454769415047227</c:v>
                  </c:pt>
                  <c:pt idx="4">
                    <c:v>3.922063040408148</c:v>
                  </c:pt>
                </c:numCache>
              </c:numRef>
            </c:minus>
          </c:errBars>
          <c:cat>
            <c:numRef>
              <c:f>記憶正答率!$Y$3:$AC$3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記憶正答率!$Y$4:$AC$4</c:f>
              <c:numCache>
                <c:formatCode>General</c:formatCode>
                <c:ptCount val="5"/>
                <c:pt idx="0">
                  <c:v>68.485714285714295</c:v>
                </c:pt>
                <c:pt idx="1">
                  <c:v>69.750000000000014</c:v>
                </c:pt>
                <c:pt idx="2">
                  <c:v>79.521428571428245</c:v>
                </c:pt>
                <c:pt idx="3">
                  <c:v>72.271428571428245</c:v>
                </c:pt>
                <c:pt idx="4">
                  <c:v>71.0071428571428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430-40E0-BFAE-F1BD77FB5367}"/>
            </c:ext>
          </c:extLst>
        </c:ser>
        <c:ser>
          <c:idx val="1"/>
          <c:order val="1"/>
          <c:tx>
            <c:strRef>
              <c:f>記憶正答率!$X$5</c:f>
              <c:strCache>
                <c:ptCount val="1"/>
                <c:pt idx="0">
                  <c:v>Suvorexanｔ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記憶正答率!$AD$5:$AH$5</c:f>
                <c:numCache>
                  <c:formatCode>General</c:formatCode>
                  <c:ptCount val="5"/>
                  <c:pt idx="0">
                    <c:v>3.032690154984174</c:v>
                  </c:pt>
                  <c:pt idx="1">
                    <c:v>3.7879679172235678</c:v>
                  </c:pt>
                  <c:pt idx="2">
                    <c:v>3.3703527804952511</c:v>
                  </c:pt>
                  <c:pt idx="3">
                    <c:v>4.3971626358900719</c:v>
                  </c:pt>
                  <c:pt idx="4">
                    <c:v>3.61806690972754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記憶正答率!$Y$3:$AC$3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記憶正答率!$Y$5:$AC$5</c:f>
              <c:numCache>
                <c:formatCode>General</c:formatCode>
                <c:ptCount val="5"/>
                <c:pt idx="0">
                  <c:v>69.335714285714303</c:v>
                </c:pt>
                <c:pt idx="1">
                  <c:v>80.021428571428245</c:v>
                </c:pt>
                <c:pt idx="2">
                  <c:v>75.628571428570481</c:v>
                </c:pt>
                <c:pt idx="3">
                  <c:v>77.314285714285717</c:v>
                </c:pt>
                <c:pt idx="4">
                  <c:v>78.1428571428560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430-40E0-BFAE-F1BD77FB5367}"/>
            </c:ext>
          </c:extLst>
        </c:ser>
        <c:ser>
          <c:idx val="2"/>
          <c:order val="2"/>
          <c:tx>
            <c:strRef>
              <c:f>記憶正答率!$X$6</c:f>
              <c:strCache>
                <c:ptCount val="1"/>
                <c:pt idx="0">
                  <c:v>Ramelteon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記憶正答率!$AD$6:$AH$6</c:f>
                <c:numCache>
                  <c:formatCode>General</c:formatCode>
                  <c:ptCount val="5"/>
                  <c:pt idx="0">
                    <c:v>3.4990175790982221</c:v>
                  </c:pt>
                  <c:pt idx="1">
                    <c:v>4.0242319391601864</c:v>
                  </c:pt>
                  <c:pt idx="2">
                    <c:v>4.92804942290556</c:v>
                  </c:pt>
                  <c:pt idx="3">
                    <c:v>3.1878799370326951</c:v>
                  </c:pt>
                  <c:pt idx="4">
                    <c:v>3.84038484139079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記憶正答率!$Y$3:$AC$3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記憶正答率!$Y$6:$AC$6</c:f>
              <c:numCache>
                <c:formatCode>General</c:formatCode>
                <c:ptCount val="5"/>
                <c:pt idx="0">
                  <c:v>69.328571428570697</c:v>
                </c:pt>
                <c:pt idx="1">
                  <c:v>74.371428571427941</c:v>
                </c:pt>
                <c:pt idx="2">
                  <c:v>71.435714285714297</c:v>
                </c:pt>
                <c:pt idx="3">
                  <c:v>73.107142857142748</c:v>
                </c:pt>
                <c:pt idx="4">
                  <c:v>79.4142857142857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430-40E0-BFAE-F1BD77FB5367}"/>
            </c:ext>
          </c:extLst>
        </c:ser>
        <c:ser>
          <c:idx val="3"/>
          <c:order val="3"/>
          <c:tx>
            <c:strRef>
              <c:f>記憶正答率!$X$7</c:f>
              <c:strCache>
                <c:ptCount val="1"/>
                <c:pt idx="0">
                  <c:v>Placebo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記憶正答率!$AD$7:$AH$7</c:f>
                <c:numCache>
                  <c:formatCode>General</c:formatCode>
                  <c:ptCount val="5"/>
                  <c:pt idx="0">
                    <c:v>5.2426595165914884</c:v>
                  </c:pt>
                  <c:pt idx="1">
                    <c:v>4.062661179027006</c:v>
                  </c:pt>
                  <c:pt idx="2">
                    <c:v>3.2315658825676432</c:v>
                  </c:pt>
                  <c:pt idx="3">
                    <c:v>3.489441913338303</c:v>
                  </c:pt>
                  <c:pt idx="4">
                    <c:v>3.0500842822336018</c:v>
                  </c:pt>
                </c:numCache>
              </c:numRef>
            </c:minus>
          </c:errBars>
          <c:cat>
            <c:numRef>
              <c:f>記憶正答率!$Y$3:$AC$3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記憶正答率!$Y$7:$AC$7</c:f>
              <c:numCache>
                <c:formatCode>General</c:formatCode>
                <c:ptCount val="5"/>
                <c:pt idx="0">
                  <c:v>74.085714285714303</c:v>
                </c:pt>
                <c:pt idx="1">
                  <c:v>76.892857142856045</c:v>
                </c:pt>
                <c:pt idx="2">
                  <c:v>76.892857142856045</c:v>
                </c:pt>
                <c:pt idx="3">
                  <c:v>70.592857142856161</c:v>
                </c:pt>
                <c:pt idx="4">
                  <c:v>72.2714285714282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430-40E0-BFAE-F1BD77FB53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063721576"/>
        <c:axId val="-2128363544"/>
      </c:lineChart>
      <c:catAx>
        <c:axId val="-2063721576"/>
        <c:scaling>
          <c:orientation val="minMax"/>
        </c:scaling>
        <c:delete val="0"/>
        <c:axPos val="b"/>
        <c:numFmt formatCode="h:mm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128363544"/>
        <c:crosses val="autoZero"/>
        <c:auto val="1"/>
        <c:lblAlgn val="ctr"/>
        <c:lblOffset val="100"/>
        <c:noMultiLvlLbl val="0"/>
      </c:catAx>
      <c:valAx>
        <c:axId val="-2128363544"/>
        <c:scaling>
          <c:orientation val="minMax"/>
          <c:min val="65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ja-JP"/>
                </a:pPr>
                <a:r>
                  <a:rPr lang="ja-JP" altLang="en-US"/>
                  <a:t>％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063721576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7408186118994"/>
          <c:y val="0.12704743573873001"/>
          <c:w val="0.57264182372555095"/>
          <c:h val="0.84200412901370902"/>
        </c:manualLayout>
      </c:layout>
      <c:lineChart>
        <c:grouping val="standard"/>
        <c:varyColors val="0"/>
        <c:ser>
          <c:idx val="0"/>
          <c:order val="0"/>
          <c:tx>
            <c:strRef>
              <c:f>手の反応時間!$X$4</c:f>
              <c:strCache>
                <c:ptCount val="1"/>
                <c:pt idx="0">
                  <c:v>Zolpidem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手の反応時間!$AE$4:$AI$4</c:f>
                <c:numCache>
                  <c:formatCode>General</c:formatCode>
                  <c:ptCount val="5"/>
                  <c:pt idx="0">
                    <c:v>1.1716714435978E-2</c:v>
                  </c:pt>
                  <c:pt idx="1">
                    <c:v>9.5040270734170797E-3</c:v>
                  </c:pt>
                  <c:pt idx="2">
                    <c:v>9.2086404037063103E-3</c:v>
                  </c:pt>
                  <c:pt idx="3">
                    <c:v>9.85915332260426E-3</c:v>
                  </c:pt>
                  <c:pt idx="4">
                    <c:v>9.827076298239910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手の反応時間!$Y$3:$AC$3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手の反応時間!$Y$4:$AC$4</c:f>
              <c:numCache>
                <c:formatCode>General</c:formatCode>
                <c:ptCount val="5"/>
                <c:pt idx="0">
                  <c:v>0.48564285714285699</c:v>
                </c:pt>
                <c:pt idx="1">
                  <c:v>0.503428571428572</c:v>
                </c:pt>
                <c:pt idx="2">
                  <c:v>0.51442857142857201</c:v>
                </c:pt>
                <c:pt idx="3">
                  <c:v>0.497928571428571</c:v>
                </c:pt>
                <c:pt idx="4">
                  <c:v>0.49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C3F-4ABD-AA07-C3CC12F45DD9}"/>
            </c:ext>
          </c:extLst>
        </c:ser>
        <c:ser>
          <c:idx val="1"/>
          <c:order val="1"/>
          <c:tx>
            <c:strRef>
              <c:f>手の反応時間!$X$5</c:f>
              <c:strCache>
                <c:ptCount val="1"/>
                <c:pt idx="0">
                  <c:v>Suvorexanｔ</c:v>
                </c:pt>
              </c:strCache>
            </c:strRef>
          </c:tx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手の反応時間!$AE$5:$AI$5</c:f>
                <c:numCache>
                  <c:formatCode>General</c:formatCode>
                  <c:ptCount val="5"/>
                  <c:pt idx="0">
                    <c:v>1.20066046711793E-2</c:v>
                  </c:pt>
                  <c:pt idx="1">
                    <c:v>1.0274184624666199E-2</c:v>
                  </c:pt>
                  <c:pt idx="2">
                    <c:v>8.3221300935255507E-3</c:v>
                  </c:pt>
                  <c:pt idx="3">
                    <c:v>7.6384397216627698E-3</c:v>
                  </c:pt>
                  <c:pt idx="4">
                    <c:v>8.9127111880804803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手の反応時間!$Y$3:$AC$3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手の反応時間!$Y$5:$AC$5</c:f>
              <c:numCache>
                <c:formatCode>General</c:formatCode>
                <c:ptCount val="5"/>
                <c:pt idx="0">
                  <c:v>0.496285714285714</c:v>
                </c:pt>
                <c:pt idx="1">
                  <c:v>0.50885714285714301</c:v>
                </c:pt>
                <c:pt idx="2">
                  <c:v>0.50307142857142895</c:v>
                </c:pt>
                <c:pt idx="3">
                  <c:v>0.49207142857142799</c:v>
                </c:pt>
                <c:pt idx="4">
                  <c:v>0.4975714285714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C3F-4ABD-AA07-C3CC12F45DD9}"/>
            </c:ext>
          </c:extLst>
        </c:ser>
        <c:ser>
          <c:idx val="2"/>
          <c:order val="2"/>
          <c:tx>
            <c:strRef>
              <c:f>手の反応時間!$X$6</c:f>
              <c:strCache>
                <c:ptCount val="1"/>
                <c:pt idx="0">
                  <c:v>Ramelteon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手の反応時間!$AE$6:$AI$6</c:f>
                <c:numCache>
                  <c:formatCode>General</c:formatCode>
                  <c:ptCount val="5"/>
                  <c:pt idx="0">
                    <c:v>8.6344750926497394E-3</c:v>
                  </c:pt>
                  <c:pt idx="1">
                    <c:v>1.20037441830165E-2</c:v>
                  </c:pt>
                  <c:pt idx="2">
                    <c:v>1.4081674743413101E-2</c:v>
                  </c:pt>
                  <c:pt idx="3">
                    <c:v>1.10575240585111E-2</c:v>
                  </c:pt>
                  <c:pt idx="4">
                    <c:v>1.1167150891193699E-2</c:v>
                  </c:pt>
                </c:numCache>
              </c:numRef>
            </c:minus>
          </c:errBars>
          <c:cat>
            <c:numRef>
              <c:f>手の反応時間!$Y$3:$AC$3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手の反応時間!$Y$6:$AC$6</c:f>
              <c:numCache>
                <c:formatCode>General</c:formatCode>
                <c:ptCount val="5"/>
                <c:pt idx="0">
                  <c:v>0.48828571428571399</c:v>
                </c:pt>
                <c:pt idx="1">
                  <c:v>0.50521428571428595</c:v>
                </c:pt>
                <c:pt idx="2">
                  <c:v>0.50757142857142901</c:v>
                </c:pt>
                <c:pt idx="3">
                  <c:v>0.49407142857142899</c:v>
                </c:pt>
                <c:pt idx="4">
                  <c:v>0.490785714285713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C3F-4ABD-AA07-C3CC12F45DD9}"/>
            </c:ext>
          </c:extLst>
        </c:ser>
        <c:ser>
          <c:idx val="3"/>
          <c:order val="3"/>
          <c:tx>
            <c:strRef>
              <c:f>手の反応時間!$X$7</c:f>
              <c:strCache>
                <c:ptCount val="1"/>
                <c:pt idx="0">
                  <c:v>Placebo</c:v>
                </c:pt>
              </c:strCache>
            </c:strRef>
          </c:tx>
          <c:marker>
            <c:symbol val="none"/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手の反応時間!$AE$7:$AI$7</c:f>
                <c:numCache>
                  <c:formatCode>General</c:formatCode>
                  <c:ptCount val="5"/>
                  <c:pt idx="0">
                    <c:v>1.33595519952334E-2</c:v>
                  </c:pt>
                  <c:pt idx="1">
                    <c:v>9.6557097902826503E-3</c:v>
                  </c:pt>
                  <c:pt idx="2">
                    <c:v>1.19822114359086E-2</c:v>
                  </c:pt>
                  <c:pt idx="3">
                    <c:v>9.4807083308821906E-3</c:v>
                  </c:pt>
                  <c:pt idx="4">
                    <c:v>1.3068711060820399E-2</c:v>
                  </c:pt>
                </c:numCache>
              </c:numRef>
            </c:minus>
          </c:errBars>
          <c:cat>
            <c:numRef>
              <c:f>手の反応時間!$Y$3:$AC$3</c:f>
              <c:numCache>
                <c:formatCode>h:mm</c:formatCode>
                <c:ptCount val="5"/>
                <c:pt idx="0">
                  <c:v>0.91666666666666596</c:v>
                </c:pt>
                <c:pt idx="1">
                  <c:v>0.16666666666666699</c:v>
                </c:pt>
                <c:pt idx="2">
                  <c:v>0.25</c:v>
                </c:pt>
                <c:pt idx="3">
                  <c:v>0.41666666666666702</c:v>
                </c:pt>
                <c:pt idx="4">
                  <c:v>0.58333333333333304</c:v>
                </c:pt>
              </c:numCache>
            </c:numRef>
          </c:cat>
          <c:val>
            <c:numRef>
              <c:f>手の反応時間!$Y$7:$AC$7</c:f>
              <c:numCache>
                <c:formatCode>General</c:formatCode>
                <c:ptCount val="5"/>
                <c:pt idx="0">
                  <c:v>0.49207142857142899</c:v>
                </c:pt>
                <c:pt idx="1">
                  <c:v>0.50478571428571395</c:v>
                </c:pt>
                <c:pt idx="2">
                  <c:v>0.49078571428571399</c:v>
                </c:pt>
                <c:pt idx="3">
                  <c:v>0.48571428571428599</c:v>
                </c:pt>
                <c:pt idx="4">
                  <c:v>0.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C3F-4ABD-AA07-C3CC12F45D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2118558936"/>
        <c:axId val="-2134359080"/>
      </c:lineChart>
      <c:catAx>
        <c:axId val="-2118558936"/>
        <c:scaling>
          <c:orientation val="minMax"/>
        </c:scaling>
        <c:delete val="0"/>
        <c:axPos val="t"/>
        <c:numFmt formatCode="h:mm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134359080"/>
        <c:crosses val="autoZero"/>
        <c:auto val="1"/>
        <c:lblAlgn val="ctr"/>
        <c:lblOffset val="100"/>
        <c:noMultiLvlLbl val="0"/>
      </c:catAx>
      <c:valAx>
        <c:axId val="-2134359080"/>
        <c:scaling>
          <c:orientation val="maxMin"/>
          <c:min val="0.48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ja-JP"/>
                </a:pPr>
                <a:r>
                  <a:rPr lang="en-US" altLang="ja-JP"/>
                  <a:t>sec</a:t>
                </a:r>
                <a:endParaRPr lang="ja-JP" altLang="en-US"/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2118558936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8184</cdr:y>
    </cdr:from>
    <cdr:to>
      <cdr:x>0.98754</cdr:x>
      <cdr:y>0.89623</cdr:y>
    </cdr:to>
    <cdr:sp macro="" textlink="">
      <cdr:nvSpPr>
        <cdr:cNvPr id="4" name="テキスト ボックス 20">
          <a:extLst xmlns:a="http://schemas.openxmlformats.org/drawingml/2006/main">
            <a:ext uri="{FF2B5EF4-FFF2-40B4-BE49-F238E27FC236}">
              <a16:creationId xmlns:a16="http://schemas.microsoft.com/office/drawing/2014/main" id="{A803D4E6-ED77-4920-AB1A-63A0B04D393C}"/>
            </a:ext>
          </a:extLst>
        </cdr:cNvPr>
        <cdr:cNvSpPr txBox="1"/>
      </cdr:nvSpPr>
      <cdr:spPr>
        <a:xfrm xmlns:a="http://schemas.openxmlformats.org/drawingml/2006/main">
          <a:off x="0" y="3883587"/>
          <a:ext cx="2774856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kumimoji="1" lang="ja-JP" altLang="en-US" dirty="0">
            <a:latin typeface="+mj-lt"/>
          </a:endParaRPr>
        </a:p>
      </cdr:txBody>
    </cdr:sp>
  </cdr:relSizeAnchor>
  <cdr:relSizeAnchor xmlns:cdr="http://schemas.openxmlformats.org/drawingml/2006/chartDrawing">
    <cdr:from>
      <cdr:x>0.0068</cdr:x>
      <cdr:y>0.03482</cdr:y>
    </cdr:from>
    <cdr:to>
      <cdr:x>0.13926</cdr:x>
      <cdr:y>0.12238</cdr:y>
    </cdr:to>
    <cdr:sp macro="" textlink="">
      <cdr:nvSpPr>
        <cdr:cNvPr id="5" name="テキスト ボックス 22">
          <a:extLst xmlns:a="http://schemas.openxmlformats.org/drawingml/2006/main">
            <a:ext uri="{FF2B5EF4-FFF2-40B4-BE49-F238E27FC236}">
              <a16:creationId xmlns:a16="http://schemas.microsoft.com/office/drawing/2014/main" id="{7664B8B6-4987-4F83-B739-009F50D2320E}"/>
            </a:ext>
          </a:extLst>
        </cdr:cNvPr>
        <cdr:cNvSpPr txBox="1"/>
      </cdr:nvSpPr>
      <cdr:spPr>
        <a:xfrm xmlns:a="http://schemas.openxmlformats.org/drawingml/2006/main">
          <a:off x="19107" y="165245"/>
          <a:ext cx="372196" cy="41550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1000" dirty="0"/>
            <a:t>(m)</a:t>
          </a:r>
        </a:p>
        <a:p xmlns:a="http://schemas.openxmlformats.org/drawingml/2006/main">
          <a:endParaRPr kumimoji="1" lang="ja-JP" altLang="en-US" sz="1000" dirty="0"/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75725</cdr:x>
      <cdr:y>0.7551</cdr:y>
    </cdr:from>
    <cdr:to>
      <cdr:x>0.95725</cdr:x>
      <cdr:y>0.89573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77E71163-0CD0-463C-B8EC-97095DB81FE9}"/>
            </a:ext>
          </a:extLst>
        </cdr:cNvPr>
        <cdr:cNvSpPr txBox="1"/>
      </cdr:nvSpPr>
      <cdr:spPr>
        <a:xfrm xmlns:a="http://schemas.openxmlformats.org/drawingml/2006/main">
          <a:off x="3462152" y="1983066"/>
          <a:ext cx="914400" cy="36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900" dirty="0"/>
            <a:t>Time main effect</a:t>
          </a:r>
        </a:p>
        <a:p xmlns:a="http://schemas.openxmlformats.org/drawingml/2006/main">
          <a:r>
            <a:rPr lang="en-US" altLang="ja-JP" sz="900" dirty="0"/>
            <a:t>**p&lt;0.01</a:t>
          </a:r>
          <a:endParaRPr lang="ja-JP" altLang="en-US" sz="9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3142</cdr:x>
      <cdr:y>0</cdr:y>
    </cdr:from>
    <cdr:to>
      <cdr:x>0.17113</cdr:x>
      <cdr:y>0.11783</cdr:y>
    </cdr:to>
    <cdr:sp macro="" textlink="">
      <cdr:nvSpPr>
        <cdr:cNvPr id="7" name="テキスト ボックス 22">
          <a:extLst xmlns:a="http://schemas.openxmlformats.org/drawingml/2006/main">
            <a:ext uri="{FF2B5EF4-FFF2-40B4-BE49-F238E27FC236}">
              <a16:creationId xmlns:a16="http://schemas.microsoft.com/office/drawing/2014/main" id="{7664B8B6-4987-4F83-B739-009F50D2320E}"/>
            </a:ext>
          </a:extLst>
        </cdr:cNvPr>
        <cdr:cNvSpPr txBox="1"/>
      </cdr:nvSpPr>
      <cdr:spPr>
        <a:xfrm xmlns:a="http://schemas.openxmlformats.org/drawingml/2006/main">
          <a:off x="83722" y="-764706"/>
          <a:ext cx="372218" cy="415498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1000" dirty="0"/>
            <a:t>(m)</a:t>
          </a:r>
        </a:p>
        <a:p xmlns:a="http://schemas.openxmlformats.org/drawingml/2006/main">
          <a:endParaRPr kumimoji="1" lang="ja-JP" altLang="en-US" sz="1000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74608</cdr:x>
      <cdr:y>0.77752</cdr:y>
    </cdr:from>
    <cdr:to>
      <cdr:x>0.95426</cdr:x>
      <cdr:y>0.91379</cdr:y>
    </cdr:to>
    <cdr:sp macro="" textlink="">
      <cdr:nvSpPr>
        <cdr:cNvPr id="4" name="テキスト ボックス 3">
          <a:extLst xmlns:a="http://schemas.openxmlformats.org/drawingml/2006/main">
            <a:ext uri="{FF2B5EF4-FFF2-40B4-BE49-F238E27FC236}">
              <a16:creationId xmlns:a16="http://schemas.microsoft.com/office/drawing/2014/main" id="{4E033973-D183-42A8-B751-20878E8CD5FD}"/>
            </a:ext>
          </a:extLst>
        </cdr:cNvPr>
        <cdr:cNvSpPr txBox="1"/>
      </cdr:nvSpPr>
      <cdr:spPr>
        <a:xfrm xmlns:a="http://schemas.openxmlformats.org/drawingml/2006/main">
          <a:off x="3277167" y="2107363"/>
          <a:ext cx="914400" cy="36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ja-JP" sz="900" dirty="0"/>
            <a:t>Time main effect</a:t>
          </a:r>
        </a:p>
        <a:p xmlns:a="http://schemas.openxmlformats.org/drawingml/2006/main">
          <a:r>
            <a:rPr lang="en-US" altLang="ja-JP" sz="900" dirty="0"/>
            <a:t>**p&lt;0.01</a:t>
          </a:r>
          <a:endParaRPr lang="ja-JP" altLang="en-US" sz="900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76163</cdr:x>
      <cdr:y>0.80079</cdr:y>
    </cdr:from>
    <cdr:to>
      <cdr:x>0.96163</cdr:x>
      <cdr:y>0.93543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77E71163-0CD0-463C-B8EC-97095DB81FE9}"/>
            </a:ext>
          </a:extLst>
        </cdr:cNvPr>
        <cdr:cNvSpPr txBox="1"/>
      </cdr:nvSpPr>
      <cdr:spPr>
        <a:xfrm xmlns:a="http://schemas.openxmlformats.org/drawingml/2006/main">
          <a:off x="3482163" y="2196726"/>
          <a:ext cx="914400" cy="36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900" dirty="0"/>
            <a:t>Time main effect</a:t>
          </a:r>
        </a:p>
        <a:p xmlns:a="http://schemas.openxmlformats.org/drawingml/2006/main">
          <a:r>
            <a:rPr lang="en-US" altLang="ja-JP" sz="900" dirty="0"/>
            <a:t>**p&lt;0.01</a:t>
          </a:r>
          <a:endParaRPr lang="ja-JP" altLang="en-US" sz="900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77522</cdr:x>
      <cdr:y>0.81244</cdr:y>
    </cdr:from>
    <cdr:to>
      <cdr:x>0.96757</cdr:x>
      <cdr:y>0.94588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77E71163-0CD0-463C-B8EC-97095DB81FE9}"/>
            </a:ext>
          </a:extLst>
        </cdr:cNvPr>
        <cdr:cNvSpPr txBox="1"/>
      </cdr:nvSpPr>
      <cdr:spPr>
        <a:xfrm xmlns:a="http://schemas.openxmlformats.org/drawingml/2006/main">
          <a:off x="3685201" y="2248672"/>
          <a:ext cx="914400" cy="36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900" dirty="0"/>
            <a:t>Time main effect</a:t>
          </a:r>
        </a:p>
        <a:p xmlns:a="http://schemas.openxmlformats.org/drawingml/2006/main">
          <a:r>
            <a:rPr lang="en-US" altLang="ja-JP" sz="900" dirty="0"/>
            <a:t>*p&lt;0.05</a:t>
          </a:r>
          <a:endParaRPr lang="ja-JP" altLang="en-US" sz="900" dirty="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74816</cdr:x>
      <cdr:y>0.82204</cdr:y>
    </cdr:from>
    <cdr:to>
      <cdr:x>0.94977</cdr:x>
      <cdr:y>0.96953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77E71163-0CD0-463C-B8EC-97095DB81FE9}"/>
            </a:ext>
          </a:extLst>
        </cdr:cNvPr>
        <cdr:cNvSpPr txBox="1"/>
      </cdr:nvSpPr>
      <cdr:spPr>
        <a:xfrm xmlns:a="http://schemas.openxmlformats.org/drawingml/2006/main">
          <a:off x="3393287" y="2058583"/>
          <a:ext cx="914400" cy="36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900" dirty="0"/>
            <a:t>Time main effect</a:t>
          </a:r>
        </a:p>
        <a:p xmlns:a="http://schemas.openxmlformats.org/drawingml/2006/main">
          <a:r>
            <a:rPr lang="en-US" altLang="ja-JP" sz="900" dirty="0"/>
            <a:t>*p&lt;0.05</a:t>
          </a:r>
          <a:endParaRPr lang="ja-JP" altLang="en-US" sz="900" dirty="0"/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77303</cdr:x>
      <cdr:y>0.77751</cdr:y>
    </cdr:from>
    <cdr:to>
      <cdr:x>0.97303</cdr:x>
      <cdr:y>0.91214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77E71163-0CD0-463C-B8EC-97095DB81FE9}"/>
            </a:ext>
          </a:extLst>
        </cdr:cNvPr>
        <cdr:cNvSpPr txBox="1"/>
      </cdr:nvSpPr>
      <cdr:spPr>
        <a:xfrm xmlns:a="http://schemas.openxmlformats.org/drawingml/2006/main">
          <a:off x="3534302" y="2132856"/>
          <a:ext cx="914400" cy="36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900" dirty="0"/>
            <a:t>Time main effect</a:t>
          </a:r>
        </a:p>
        <a:p xmlns:a="http://schemas.openxmlformats.org/drawingml/2006/main">
          <a:r>
            <a:rPr lang="en-US" altLang="ja-JP" sz="900" dirty="0"/>
            <a:t>**p&lt;0.01</a:t>
          </a:r>
          <a:endParaRPr lang="ja-JP" altLang="en-US" sz="900" dirty="0"/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76552</cdr:x>
      <cdr:y>0.75541</cdr:y>
    </cdr:from>
    <cdr:to>
      <cdr:x>0.96552</cdr:x>
      <cdr:y>0.89005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77E71163-0CD0-463C-B8EC-97095DB81FE9}"/>
            </a:ext>
          </a:extLst>
        </cdr:cNvPr>
        <cdr:cNvSpPr txBox="1"/>
      </cdr:nvSpPr>
      <cdr:spPr>
        <a:xfrm xmlns:a="http://schemas.openxmlformats.org/drawingml/2006/main">
          <a:off x="3499946" y="2072248"/>
          <a:ext cx="914400" cy="36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900" dirty="0"/>
            <a:t>Time main effect</a:t>
          </a:r>
        </a:p>
        <a:p xmlns:a="http://schemas.openxmlformats.org/drawingml/2006/main">
          <a:r>
            <a:rPr lang="en-US" altLang="ja-JP" sz="900" dirty="0"/>
            <a:t>**p&lt;0.01</a:t>
          </a:r>
          <a:endParaRPr lang="ja-JP" altLang="en-US" sz="900" dirty="0"/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77025</cdr:x>
      <cdr:y>0.76124</cdr:y>
    </cdr:from>
    <cdr:to>
      <cdr:x>0.97025</cdr:x>
      <cdr:y>0.89587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77E71163-0CD0-463C-B8EC-97095DB81FE9}"/>
            </a:ext>
          </a:extLst>
        </cdr:cNvPr>
        <cdr:cNvSpPr txBox="1"/>
      </cdr:nvSpPr>
      <cdr:spPr>
        <a:xfrm xmlns:a="http://schemas.openxmlformats.org/drawingml/2006/main">
          <a:off x="3521573" y="2088232"/>
          <a:ext cx="914400" cy="36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900" dirty="0"/>
            <a:t>Time main effect</a:t>
          </a:r>
        </a:p>
        <a:p xmlns:a="http://schemas.openxmlformats.org/drawingml/2006/main">
          <a:r>
            <a:rPr lang="en-US" altLang="ja-JP" sz="900" dirty="0"/>
            <a:t>**p&lt;0.01</a:t>
          </a:r>
          <a:endParaRPr lang="ja-JP" altLang="en-US" sz="9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14089B-702D-B24B-8113-739A573B9C47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FCF053-C8FC-174A-88F5-B48A6CD081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90989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4354476-A91F-4ECD-8EDC-3B61C849D1E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827193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2" name="Rectangle 2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5843" name="Rectangle 3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0413124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4354476-A91F-4ECD-8EDC-3B61C849D1E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37442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5226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027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1373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4434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0750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5493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174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2574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9723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776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2690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55F663-E487-A94F-937A-74F79769B718}" type="datetimeFigureOut">
              <a:rPr kumimoji="1" lang="ja-JP" altLang="en-US" smtClean="0"/>
              <a:t>2022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E5FEA-1021-0E4A-8FD6-6BD643A4AB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7234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41786373-5C7D-4F3C-B251-7FC72456C6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269997"/>
              </p:ext>
            </p:extLst>
          </p:nvPr>
        </p:nvGraphicFramePr>
        <p:xfrm>
          <a:off x="467544" y="1556792"/>
          <a:ext cx="8394106" cy="3495194"/>
        </p:xfrm>
        <a:graphic>
          <a:graphicData uri="http://schemas.openxmlformats.org/drawingml/2006/table">
            <a:tbl>
              <a:tblPr/>
              <a:tblGrid>
                <a:gridCol w="658300">
                  <a:extLst>
                    <a:ext uri="{9D8B030D-6E8A-4147-A177-3AD203B41FA5}">
                      <a16:colId xmlns:a16="http://schemas.microsoft.com/office/drawing/2014/main" val="2419059908"/>
                    </a:ext>
                  </a:extLst>
                </a:gridCol>
                <a:gridCol w="663716">
                  <a:extLst>
                    <a:ext uri="{9D8B030D-6E8A-4147-A177-3AD203B41FA5}">
                      <a16:colId xmlns:a16="http://schemas.microsoft.com/office/drawing/2014/main" val="783717883"/>
                    </a:ext>
                  </a:extLst>
                </a:gridCol>
                <a:gridCol w="707209">
                  <a:extLst>
                    <a:ext uri="{9D8B030D-6E8A-4147-A177-3AD203B41FA5}">
                      <a16:colId xmlns:a16="http://schemas.microsoft.com/office/drawing/2014/main" val="1331765890"/>
                    </a:ext>
                  </a:extLst>
                </a:gridCol>
                <a:gridCol w="707209">
                  <a:extLst>
                    <a:ext uri="{9D8B030D-6E8A-4147-A177-3AD203B41FA5}">
                      <a16:colId xmlns:a16="http://schemas.microsoft.com/office/drawing/2014/main" val="4237803883"/>
                    </a:ext>
                  </a:extLst>
                </a:gridCol>
                <a:gridCol w="707209">
                  <a:extLst>
                    <a:ext uri="{9D8B030D-6E8A-4147-A177-3AD203B41FA5}">
                      <a16:colId xmlns:a16="http://schemas.microsoft.com/office/drawing/2014/main" val="2788415718"/>
                    </a:ext>
                  </a:extLst>
                </a:gridCol>
                <a:gridCol w="707209">
                  <a:extLst>
                    <a:ext uri="{9D8B030D-6E8A-4147-A177-3AD203B41FA5}">
                      <a16:colId xmlns:a16="http://schemas.microsoft.com/office/drawing/2014/main" val="1960006717"/>
                    </a:ext>
                  </a:extLst>
                </a:gridCol>
                <a:gridCol w="707209">
                  <a:extLst>
                    <a:ext uri="{9D8B030D-6E8A-4147-A177-3AD203B41FA5}">
                      <a16:colId xmlns:a16="http://schemas.microsoft.com/office/drawing/2014/main" val="2672026343"/>
                    </a:ext>
                  </a:extLst>
                </a:gridCol>
                <a:gridCol w="707209">
                  <a:extLst>
                    <a:ext uri="{9D8B030D-6E8A-4147-A177-3AD203B41FA5}">
                      <a16:colId xmlns:a16="http://schemas.microsoft.com/office/drawing/2014/main" val="2437237017"/>
                    </a:ext>
                  </a:extLst>
                </a:gridCol>
                <a:gridCol w="707209">
                  <a:extLst>
                    <a:ext uri="{9D8B030D-6E8A-4147-A177-3AD203B41FA5}">
                      <a16:colId xmlns:a16="http://schemas.microsoft.com/office/drawing/2014/main" val="2830196481"/>
                    </a:ext>
                  </a:extLst>
                </a:gridCol>
                <a:gridCol w="707209">
                  <a:extLst>
                    <a:ext uri="{9D8B030D-6E8A-4147-A177-3AD203B41FA5}">
                      <a16:colId xmlns:a16="http://schemas.microsoft.com/office/drawing/2014/main" val="1307818964"/>
                    </a:ext>
                  </a:extLst>
                </a:gridCol>
                <a:gridCol w="707209">
                  <a:extLst>
                    <a:ext uri="{9D8B030D-6E8A-4147-A177-3AD203B41FA5}">
                      <a16:colId xmlns:a16="http://schemas.microsoft.com/office/drawing/2014/main" val="3025892924"/>
                    </a:ext>
                  </a:extLst>
                </a:gridCol>
                <a:gridCol w="707209">
                  <a:extLst>
                    <a:ext uri="{9D8B030D-6E8A-4147-A177-3AD203B41FA5}">
                      <a16:colId xmlns:a16="http://schemas.microsoft.com/office/drawing/2014/main" val="3534805882"/>
                    </a:ext>
                  </a:extLst>
                </a:gridCol>
              </a:tblGrid>
              <a:tr h="72008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Zolpidem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Suvorexan</a:t>
                      </a:r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ｔ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amelteon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Placebo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Freedman test / R-ANOVA ,p</a:t>
                      </a:r>
                    </a:p>
                  </a:txBody>
                  <a:tcPr marL="3499" marR="3499" marT="349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Post-hoc test</a:t>
                      </a:r>
                    </a:p>
                  </a:txBody>
                  <a:tcPr marL="3499" marR="3499" marT="349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9218481"/>
                  </a:ext>
                </a:extLst>
              </a:tr>
              <a:tr h="38363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Mean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SEM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Mean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SEM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Mean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SEM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Mean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SEM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9148171"/>
                  </a:ext>
                </a:extLst>
              </a:tr>
              <a:tr h="38363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TST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(m)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17.8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.5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36.6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.7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29.8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.3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22.8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.0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16 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+mn-ea"/>
                        </a:rPr>
                        <a:t>ns</a:t>
                      </a:r>
                      <a:endParaRPr lang="ja-JP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</a:endParaRP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3475440"/>
                  </a:ext>
                </a:extLst>
              </a:tr>
              <a:tr h="38363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SL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(m)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6.1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6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.2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7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.8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.3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7.3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7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03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+mn-ea"/>
                        </a:rPr>
                        <a:t>ns</a:t>
                      </a:r>
                      <a:endParaRPr lang="ja-JP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</a:endParaRP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8324786"/>
                  </a:ext>
                </a:extLst>
              </a:tr>
              <a:tr h="38363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REM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(m)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1.9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.5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2.1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.7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2.6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.6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1.5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.3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001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4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Z&lt;S</a:t>
                      </a:r>
                    </a:p>
                    <a:p>
                      <a:pPr algn="ctr" rtl="0" fontAlgn="b"/>
                      <a:r>
                        <a:rPr lang="en-US" altLang="ja-JP" sz="14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(p=0.002)</a:t>
                      </a:r>
                    </a:p>
                    <a:p>
                      <a:pPr algn="ctr" rtl="0" fontAlgn="b"/>
                      <a:r>
                        <a:rPr lang="en-US" altLang="ja-JP" sz="14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 </a:t>
                      </a:r>
                      <a:r>
                        <a:rPr lang="ja-JP" altLang="en-US" sz="1400" dirty="0">
                          <a:solidFill>
                            <a:srgbClr val="FF0000"/>
                          </a:solidFill>
                        </a:rPr>
                        <a:t> </a:t>
                      </a:r>
                      <a:r>
                        <a:rPr lang="en-US" altLang="ja-JP" sz="14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S&gt;P</a:t>
                      </a:r>
                    </a:p>
                    <a:p>
                      <a:pPr algn="ctr" rtl="0" fontAlgn="b"/>
                      <a:r>
                        <a:rPr lang="en-US" altLang="ja-JP" sz="14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(p=0.017)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6124361"/>
                  </a:ext>
                </a:extLst>
              </a:tr>
              <a:tr h="38363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stage1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(m)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9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.9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2.3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.1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7.3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.4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5.2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.3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08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+mn-ea"/>
                        </a:rPr>
                        <a:t>ns</a:t>
                      </a:r>
                      <a:endParaRPr lang="ja-JP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</a:endParaRP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1882888"/>
                  </a:ext>
                </a:extLst>
              </a:tr>
              <a:tr h="38363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stage2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(m)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4.9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.7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6.1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.0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1.2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.2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7.6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.3</a:t>
                      </a: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13</a:t>
                      </a:r>
                    </a:p>
                  </a:txBody>
                  <a:tcPr marL="3499" marR="3499" marT="349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+mn-ea"/>
                        </a:rPr>
                        <a:t>ns</a:t>
                      </a:r>
                      <a:endParaRPr lang="ja-JP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</a:endParaRPr>
                    </a:p>
                  </a:txBody>
                  <a:tcPr marL="3499" marR="3499" marT="349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8688740"/>
                  </a:ext>
                </a:extLst>
              </a:tr>
            </a:tbl>
          </a:graphicData>
        </a:graphic>
      </p:graphicFrame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7386B6AB-FE40-4084-9F61-7BC38E418193}"/>
              </a:ext>
            </a:extLst>
          </p:cNvPr>
          <p:cNvSpPr/>
          <p:nvPr/>
        </p:nvSpPr>
        <p:spPr>
          <a:xfrm>
            <a:off x="2185035" y="1012182"/>
            <a:ext cx="497568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2400" b="1" dirty="0">
                <a:solidFill>
                  <a:prstClr val="black"/>
                </a:solidFill>
              </a:rPr>
              <a:t>Table.S1  EEG results (23:00-6:00)</a:t>
            </a:r>
            <a:endParaRPr lang="ja-JP" altLang="en-US" sz="2400" b="1" dirty="0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D8420453-BA20-4700-A883-4E1C4D42A1A0}"/>
              </a:ext>
            </a:extLst>
          </p:cNvPr>
          <p:cNvSpPr/>
          <p:nvPr/>
        </p:nvSpPr>
        <p:spPr>
          <a:xfrm>
            <a:off x="2699792" y="5224434"/>
            <a:ext cx="61926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dirty="0">
                <a:solidFill>
                  <a:prstClr val="black"/>
                </a:solidFill>
              </a:rPr>
              <a:t>　</a:t>
            </a:r>
            <a:r>
              <a:rPr lang="en-US" altLang="ja-JP" sz="1200" dirty="0">
                <a:solidFill>
                  <a:prstClr val="black"/>
                </a:solidFill>
              </a:rPr>
              <a:t>R-ANOVA or  </a:t>
            </a:r>
            <a:r>
              <a:rPr lang="en-US" altLang="ja-JP" sz="1200" dirty="0">
                <a:solidFill>
                  <a:srgbClr val="000000"/>
                </a:solidFill>
                <a:latin typeface="Calibri" panose="020F0502020204030204" pitchFamily="34" charset="0"/>
              </a:rPr>
              <a:t>Freedman test</a:t>
            </a:r>
            <a:r>
              <a:rPr lang="en-US" altLang="ja-JP" sz="1200" dirty="0">
                <a:solidFill>
                  <a:prstClr val="black"/>
                </a:solidFill>
              </a:rPr>
              <a:t> &amp; </a:t>
            </a:r>
            <a:r>
              <a:rPr lang="en-US" altLang="ja-JP" sz="1200" dirty="0">
                <a:solidFill>
                  <a:srgbClr val="000000"/>
                </a:solidFill>
                <a:latin typeface="Calibri" panose="020F0502020204030204" pitchFamily="34" charset="0"/>
              </a:rPr>
              <a:t>Post-hoc test (</a:t>
            </a:r>
            <a:r>
              <a:rPr lang="en-US" altLang="ja-JP" sz="1200" dirty="0"/>
              <a:t>Bonferroni or Steel-</a:t>
            </a:r>
            <a:r>
              <a:rPr lang="en-US" altLang="ja-JP" sz="1200" dirty="0" err="1"/>
              <a:t>Dwass</a:t>
            </a:r>
            <a:r>
              <a:rPr lang="en-US" altLang="ja-JP" sz="1200" dirty="0"/>
              <a:t>)   </a:t>
            </a:r>
            <a:endParaRPr lang="en-US" altLang="ja-JP" sz="1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42194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121"/>
          <p:cNvSpPr txBox="1">
            <a:spLocks noChangeArrowheads="1"/>
          </p:cNvSpPr>
          <p:nvPr/>
        </p:nvSpPr>
        <p:spPr bwMode="auto">
          <a:xfrm>
            <a:off x="755576" y="188640"/>
            <a:ext cx="7272808" cy="5125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80897" tIns="40448" rIns="80897" bIns="40448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800" b="1" dirty="0">
                <a:solidFill>
                  <a:prstClr val="black"/>
                </a:solidFill>
              </a:rPr>
              <a:t>Table.S2 Subjective assessments</a:t>
            </a:r>
            <a:endParaRPr lang="en-US" altLang="ja-JP" sz="2800" dirty="0">
              <a:solidFill>
                <a:prstClr val="black"/>
              </a:solidFill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4644008" y="6093296"/>
            <a:ext cx="409028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sz="1200" dirty="0">
                <a:solidFill>
                  <a:prstClr val="black"/>
                </a:solidFill>
              </a:rPr>
              <a:t>　</a:t>
            </a:r>
            <a:r>
              <a:rPr lang="en-US" altLang="ja-JP" sz="1200" dirty="0">
                <a:solidFill>
                  <a:prstClr val="black"/>
                </a:solidFill>
              </a:rPr>
              <a:t>R-2way ANOVA &amp; </a:t>
            </a:r>
            <a:r>
              <a:rPr lang="en-US" altLang="ja-JP" sz="1200" dirty="0"/>
              <a:t>Bonferroni</a:t>
            </a:r>
            <a:r>
              <a:rPr lang="en-US" altLang="ja-JP" sz="1200" dirty="0">
                <a:solidFill>
                  <a:prstClr val="black"/>
                </a:solidFill>
              </a:rPr>
              <a:t>          </a:t>
            </a:r>
            <a:r>
              <a:rPr lang="ja-JP" altLang="en-US" sz="1200" dirty="0">
                <a:solidFill>
                  <a:prstClr val="black"/>
                </a:solidFill>
              </a:rPr>
              <a:t>* </a:t>
            </a:r>
            <a:r>
              <a:rPr lang="en-US" altLang="ja-JP" sz="1200" dirty="0">
                <a:solidFill>
                  <a:prstClr val="black"/>
                </a:solidFill>
              </a:rPr>
              <a:t>p&lt;0.05</a:t>
            </a:r>
            <a:r>
              <a:rPr lang="ja-JP" altLang="en-US" sz="1200" dirty="0">
                <a:solidFill>
                  <a:prstClr val="black"/>
                </a:solidFill>
              </a:rPr>
              <a:t>　 ** </a:t>
            </a:r>
            <a:r>
              <a:rPr lang="en-US" altLang="ja-JP" sz="1200" dirty="0">
                <a:solidFill>
                  <a:prstClr val="black"/>
                </a:solidFill>
              </a:rPr>
              <a:t>p&lt;0.01</a:t>
            </a: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68D9FC18-D6A8-448C-81D4-D1460F2DCB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4580926"/>
              </p:ext>
            </p:extLst>
          </p:nvPr>
        </p:nvGraphicFramePr>
        <p:xfrm>
          <a:off x="251520" y="908720"/>
          <a:ext cx="8712969" cy="5112568"/>
        </p:xfrm>
        <a:graphic>
          <a:graphicData uri="http://schemas.openxmlformats.org/drawingml/2006/table">
            <a:tbl>
              <a:tblPr/>
              <a:tblGrid>
                <a:gridCol w="1116100">
                  <a:extLst>
                    <a:ext uri="{9D8B030D-6E8A-4147-A177-3AD203B41FA5}">
                      <a16:colId xmlns:a16="http://schemas.microsoft.com/office/drawing/2014/main" val="2172580309"/>
                    </a:ext>
                  </a:extLst>
                </a:gridCol>
                <a:gridCol w="374874">
                  <a:extLst>
                    <a:ext uri="{9D8B030D-6E8A-4147-A177-3AD203B41FA5}">
                      <a16:colId xmlns:a16="http://schemas.microsoft.com/office/drawing/2014/main" val="2524618634"/>
                    </a:ext>
                  </a:extLst>
                </a:gridCol>
                <a:gridCol w="613428">
                  <a:extLst>
                    <a:ext uri="{9D8B030D-6E8A-4147-A177-3AD203B41FA5}">
                      <a16:colId xmlns:a16="http://schemas.microsoft.com/office/drawing/2014/main" val="3060626711"/>
                    </a:ext>
                  </a:extLst>
                </a:gridCol>
                <a:gridCol w="340794">
                  <a:extLst>
                    <a:ext uri="{9D8B030D-6E8A-4147-A177-3AD203B41FA5}">
                      <a16:colId xmlns:a16="http://schemas.microsoft.com/office/drawing/2014/main" val="3397457740"/>
                    </a:ext>
                  </a:extLst>
                </a:gridCol>
                <a:gridCol w="707147">
                  <a:extLst>
                    <a:ext uri="{9D8B030D-6E8A-4147-A177-3AD203B41FA5}">
                      <a16:colId xmlns:a16="http://schemas.microsoft.com/office/drawing/2014/main" val="609650495"/>
                    </a:ext>
                  </a:extLst>
                </a:gridCol>
                <a:gridCol w="340794">
                  <a:extLst>
                    <a:ext uri="{9D8B030D-6E8A-4147-A177-3AD203B41FA5}">
                      <a16:colId xmlns:a16="http://schemas.microsoft.com/office/drawing/2014/main" val="714568633"/>
                    </a:ext>
                  </a:extLst>
                </a:gridCol>
                <a:gridCol w="704308">
                  <a:extLst>
                    <a:ext uri="{9D8B030D-6E8A-4147-A177-3AD203B41FA5}">
                      <a16:colId xmlns:a16="http://schemas.microsoft.com/office/drawing/2014/main" val="784122496"/>
                    </a:ext>
                  </a:extLst>
                </a:gridCol>
                <a:gridCol w="340794">
                  <a:extLst>
                    <a:ext uri="{9D8B030D-6E8A-4147-A177-3AD203B41FA5}">
                      <a16:colId xmlns:a16="http://schemas.microsoft.com/office/drawing/2014/main" val="2262293968"/>
                    </a:ext>
                  </a:extLst>
                </a:gridCol>
                <a:gridCol w="536751">
                  <a:extLst>
                    <a:ext uri="{9D8B030D-6E8A-4147-A177-3AD203B41FA5}">
                      <a16:colId xmlns:a16="http://schemas.microsoft.com/office/drawing/2014/main" val="1339773482"/>
                    </a:ext>
                  </a:extLst>
                </a:gridCol>
                <a:gridCol w="340794">
                  <a:extLst>
                    <a:ext uri="{9D8B030D-6E8A-4147-A177-3AD203B41FA5}">
                      <a16:colId xmlns:a16="http://schemas.microsoft.com/office/drawing/2014/main" val="4065145422"/>
                    </a:ext>
                  </a:extLst>
                </a:gridCol>
                <a:gridCol w="571003">
                  <a:extLst>
                    <a:ext uri="{9D8B030D-6E8A-4147-A177-3AD203B41FA5}">
                      <a16:colId xmlns:a16="http://schemas.microsoft.com/office/drawing/2014/main" val="1953791992"/>
                    </a:ext>
                  </a:extLst>
                </a:gridCol>
                <a:gridCol w="571003">
                  <a:extLst>
                    <a:ext uri="{9D8B030D-6E8A-4147-A177-3AD203B41FA5}">
                      <a16:colId xmlns:a16="http://schemas.microsoft.com/office/drawing/2014/main" val="1092629138"/>
                    </a:ext>
                  </a:extLst>
                </a:gridCol>
                <a:gridCol w="571003">
                  <a:extLst>
                    <a:ext uri="{9D8B030D-6E8A-4147-A177-3AD203B41FA5}">
                      <a16:colId xmlns:a16="http://schemas.microsoft.com/office/drawing/2014/main" val="2866470834"/>
                    </a:ext>
                  </a:extLst>
                </a:gridCol>
                <a:gridCol w="1584176">
                  <a:extLst>
                    <a:ext uri="{9D8B030D-6E8A-4147-A177-3AD203B41FA5}">
                      <a16:colId xmlns:a16="http://schemas.microsoft.com/office/drawing/2014/main" val="2823903250"/>
                    </a:ext>
                  </a:extLst>
                </a:gridCol>
              </a:tblGrid>
              <a:tr h="819541"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Zolpidem</a:t>
                      </a:r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Suvorexant</a:t>
                      </a:r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Ramelteon</a:t>
                      </a:r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Placebo</a:t>
                      </a:r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Drug Main effect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Drug Post hoc test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Time Main effect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Time Post hoc test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8001700"/>
                  </a:ext>
                </a:extLst>
              </a:tr>
              <a:tr h="364235"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Mean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SEM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Mean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SEM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Mean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SEM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Mean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SEM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3171654"/>
                  </a:ext>
                </a:extLst>
              </a:tr>
              <a:tr h="98219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ＭＳ Ｐゴシック" panose="020B0600070205080204" pitchFamily="50" charset="-128"/>
                        </a:rPr>
                        <a:t>Stanford Sleepiness Scale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ＭＳ Ｐゴシック" panose="020B0600070205080204" pitchFamily="50" charset="-128"/>
                        </a:rPr>
                        <a:t>(SSS)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2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0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3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0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3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0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3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0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ＭＳ Ｐゴシック" panose="020B0600070205080204" pitchFamily="50" charset="-128"/>
                          <a:cs typeface="+mn-cs"/>
                        </a:rPr>
                        <a:t>ns</a:t>
                      </a:r>
                      <a:endParaRPr kumimoji="1" lang="ja-JP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ＭＳ Ｐゴシック" panose="020B0600070205080204" pitchFamily="50" charset="-128"/>
                        <a:cs typeface="+mn-cs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0.00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21&lt;4**,21&lt;6**,4&gt;8**,4&gt;10**,</a:t>
                      </a:r>
                    </a:p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4&gt;12**,4&gt;14**,4&gt;16**,</a:t>
                      </a:r>
                    </a:p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&lt;8*,6&gt;14*,6&gt;16*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528263"/>
                  </a:ext>
                </a:extLst>
              </a:tr>
              <a:tr h="98219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ＭＳ Ｐゴシック" panose="020B0600070205080204" pitchFamily="50" charset="-128"/>
                        </a:rPr>
                        <a:t>Alertness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ＭＳ Ｐゴシック" panose="020B0600070205080204" pitchFamily="50" charset="-128"/>
                        </a:rPr>
                        <a:t> (VAS)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7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7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0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7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1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7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ＭＳ Ｐゴシック" panose="020B0600070205080204" pitchFamily="50" charset="-128"/>
                          <a:cs typeface="+mn-cs"/>
                        </a:rPr>
                        <a:t>ns</a:t>
                      </a:r>
                      <a:endParaRPr kumimoji="1" lang="ja-JP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ＭＳ Ｐゴシック" panose="020B0600070205080204" pitchFamily="50" charset="-128"/>
                        <a:cs typeface="+mn-cs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ＭＳ Ｐゴシック" panose="020B0600070205080204" pitchFamily="50" charset="-128"/>
                          <a:cs typeface="+mn-cs"/>
                        </a:rPr>
                        <a:t>0.00</a:t>
                      </a:r>
                      <a:endParaRPr kumimoji="1" lang="ja-JP" altLang="en-US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+mn-cs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21&gt;4**,21&gt;6**,4&lt;6*,4&lt;8**,</a:t>
                      </a:r>
                    </a:p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4&lt;10**,4&lt;12**,4&lt;14**,4&lt;16**,</a:t>
                      </a:r>
                    </a:p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&lt;8**,6&lt;10*,6&lt;12*,6&lt;14*,6&lt;16**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230217"/>
                  </a:ext>
                </a:extLst>
              </a:tr>
              <a:tr h="98219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ＭＳ Ｐゴシック" panose="020B0600070205080204" pitchFamily="50" charset="-128"/>
                        </a:rPr>
                        <a:t>Well-being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ＭＳ Ｐゴシック" panose="020B0600070205080204" pitchFamily="50" charset="-128"/>
                        </a:rPr>
                        <a:t> (VAS)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6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1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59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.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2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ＭＳ Ｐゴシック" panose="020B0600070205080204" pitchFamily="50" charset="-128"/>
                          <a:cs typeface="+mn-cs"/>
                        </a:rPr>
                        <a:t>ns</a:t>
                      </a:r>
                      <a:endParaRPr kumimoji="1" lang="ja-JP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ＭＳ Ｐゴシック" panose="020B0600070205080204" pitchFamily="50" charset="-128"/>
                        <a:cs typeface="+mn-cs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ＭＳ Ｐゴシック" panose="020B0600070205080204" pitchFamily="50" charset="-128"/>
                          <a:cs typeface="+mn-cs"/>
                        </a:rPr>
                        <a:t>0.00</a:t>
                      </a:r>
                      <a:endParaRPr kumimoji="1" lang="ja-JP" altLang="en-US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+mn-cs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21&gt;4**,21&gt;6*,4&lt;6*,4&lt;8**,</a:t>
                      </a:r>
                    </a:p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4&lt;10**,4&lt;12**,4&lt;14**,4&lt;16**,</a:t>
                      </a:r>
                    </a:p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&lt;8**,6&lt;12**,6&lt;14**,6&lt;16*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8999397"/>
                  </a:ext>
                </a:extLst>
              </a:tr>
              <a:tr h="98219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ＭＳ Ｐゴシック" panose="020B0600070205080204" pitchFamily="50" charset="-128"/>
                        </a:rPr>
                        <a:t>Fatigue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ＭＳ Ｐゴシック" panose="020B0600070205080204" pitchFamily="50" charset="-128"/>
                        </a:rPr>
                        <a:t> (VAS)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6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59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58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59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6.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ＭＳ Ｐゴシック" panose="020B0600070205080204" pitchFamily="50" charset="-128"/>
                          <a:cs typeface="+mn-cs"/>
                        </a:rPr>
                        <a:t>ns</a:t>
                      </a:r>
                      <a:endParaRPr kumimoji="1" lang="ja-JP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ＭＳ Ｐゴシック" panose="020B0600070205080204" pitchFamily="50" charset="-128"/>
                        <a:cs typeface="+mn-cs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ＭＳ Ｐゴシック" panose="020B0600070205080204" pitchFamily="50" charset="-128"/>
                          <a:cs typeface="+mn-cs"/>
                        </a:rPr>
                        <a:t>0.00</a:t>
                      </a:r>
                      <a:endParaRPr kumimoji="1" lang="ja-JP" altLang="en-US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+mn-cs"/>
                      </a:endParaRP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21&gt;4**,21&gt;6*,4&lt;6*,4&lt;8**,</a:t>
                      </a:r>
                    </a:p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4&lt;10**,4&lt;12**,4&lt;14**,4&lt;16**</a:t>
                      </a:r>
                    </a:p>
                    <a:p>
                      <a:pPr algn="ctr" rtl="0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ＭＳ Ｐゴシック" panose="020B0600070205080204" pitchFamily="50" charset="-128"/>
                        </a:rPr>
                        <a:t>,6&lt;8**,6&lt;12*,6&lt;14*</a:t>
                      </a:r>
                    </a:p>
                  </a:txBody>
                  <a:tcPr marL="8058" marR="8058" marT="80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17970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301204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D2872E5-C926-451C-88FA-9B5655F8DB0F}"/>
              </a:ext>
            </a:extLst>
          </p:cNvPr>
          <p:cNvSpPr txBox="1"/>
          <p:nvPr/>
        </p:nvSpPr>
        <p:spPr>
          <a:xfrm>
            <a:off x="312908" y="5630242"/>
            <a:ext cx="853747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>
                <a:solidFill>
                  <a:prstClr val="black"/>
                </a:solidFill>
              </a:rPr>
              <a:t>Fig.S1</a:t>
            </a:r>
            <a:r>
              <a:rPr lang="ja-JP" altLang="en-US" sz="2400" dirty="0">
                <a:solidFill>
                  <a:prstClr val="black"/>
                </a:solidFill>
              </a:rPr>
              <a:t>　</a:t>
            </a:r>
            <a:r>
              <a:rPr lang="en-US" altLang="ja-JP" sz="2400" dirty="0">
                <a:solidFill>
                  <a:prstClr val="black"/>
                </a:solidFill>
              </a:rPr>
              <a:t>PSG results of  (a) N3 sleep stage in the first period </a:t>
            </a:r>
            <a:r>
              <a:rPr lang="ja-JP" altLang="en-US" sz="2400" dirty="0">
                <a:solidFill>
                  <a:prstClr val="black"/>
                </a:solidFill>
              </a:rPr>
              <a:t>（</a:t>
            </a:r>
            <a:r>
              <a:rPr lang="en-US" altLang="ja-JP" sz="2400" dirty="0">
                <a:solidFill>
                  <a:prstClr val="black"/>
                </a:solidFill>
              </a:rPr>
              <a:t>23:00-4:00</a:t>
            </a:r>
            <a:r>
              <a:rPr lang="ja-JP" altLang="en-US" sz="2400" dirty="0">
                <a:solidFill>
                  <a:prstClr val="black"/>
                </a:solidFill>
              </a:rPr>
              <a:t>）</a:t>
            </a:r>
            <a:r>
              <a:rPr lang="en-US" altLang="ja-JP" sz="2400" dirty="0">
                <a:solidFill>
                  <a:prstClr val="black"/>
                </a:solidFill>
              </a:rPr>
              <a:t> and (b) N2 sleep stage in second period under the 4 conditions</a:t>
            </a:r>
            <a:r>
              <a:rPr lang="ja-JP" altLang="en-US" sz="2400" dirty="0">
                <a:solidFill>
                  <a:prstClr val="black"/>
                </a:solidFill>
              </a:rPr>
              <a:t>（</a:t>
            </a:r>
            <a:r>
              <a:rPr lang="en-US" altLang="ja-JP" sz="2400" dirty="0">
                <a:solidFill>
                  <a:prstClr val="black"/>
                </a:solidFill>
              </a:rPr>
              <a:t>4:30-6:00</a:t>
            </a:r>
            <a:r>
              <a:rPr lang="ja-JP" altLang="en-US" sz="2400" dirty="0">
                <a:solidFill>
                  <a:prstClr val="black"/>
                </a:solidFill>
              </a:rPr>
              <a:t>）</a:t>
            </a:r>
            <a:r>
              <a:rPr lang="en-US" altLang="ja-JP" sz="2400" dirty="0">
                <a:solidFill>
                  <a:prstClr val="black"/>
                </a:solidFill>
              </a:rPr>
              <a:t> </a:t>
            </a:r>
            <a:endParaRPr lang="ja-JP" altLang="en-US" sz="2400" dirty="0"/>
          </a:p>
          <a:p>
            <a:pPr algn="ctr"/>
            <a:endParaRPr lang="ja-JP" altLang="en-US" sz="24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768E9EB-17DA-44BC-9D96-F23E21E2B437}"/>
              </a:ext>
            </a:extLst>
          </p:cNvPr>
          <p:cNvSpPr txBox="1"/>
          <p:nvPr/>
        </p:nvSpPr>
        <p:spPr>
          <a:xfrm>
            <a:off x="1783492" y="4626194"/>
            <a:ext cx="1736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3-3. Stage 3</a:t>
            </a:r>
            <a:endParaRPr kumimoji="1" lang="ja-JP" altLang="en-US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8064057-0B6D-4BA1-9872-58D3C396EEE7}"/>
              </a:ext>
            </a:extLst>
          </p:cNvPr>
          <p:cNvSpPr txBox="1"/>
          <p:nvPr/>
        </p:nvSpPr>
        <p:spPr>
          <a:xfrm>
            <a:off x="1220711" y="308668"/>
            <a:ext cx="3642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(m)</a:t>
            </a:r>
          </a:p>
          <a:p>
            <a:endParaRPr kumimoji="1" lang="ja-JP" altLang="en-US" sz="1000" dirty="0"/>
          </a:p>
        </p:txBody>
      </p:sp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00000000-0008-0000-05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6113156"/>
              </p:ext>
            </p:extLst>
          </p:nvPr>
        </p:nvGraphicFramePr>
        <p:xfrm>
          <a:off x="1185692" y="273218"/>
          <a:ext cx="2809875" cy="47453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8E9052B0-2C51-4594-8C60-ACA28E0E40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9550015"/>
              </p:ext>
            </p:extLst>
          </p:nvPr>
        </p:nvGraphicFramePr>
        <p:xfrm>
          <a:off x="4920236" y="764706"/>
          <a:ext cx="2664296" cy="35263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3FA327FD-C21F-45DA-A20D-3FEF9C203D9A}"/>
              </a:ext>
            </a:extLst>
          </p:cNvPr>
          <p:cNvSpPr/>
          <p:nvPr/>
        </p:nvSpPr>
        <p:spPr>
          <a:xfrm>
            <a:off x="4920236" y="4336665"/>
            <a:ext cx="260552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/>
              <a:t>Fig.S1 (b) N2 sleep stage</a:t>
            </a:r>
          </a:p>
          <a:p>
            <a:pPr algn="ctr"/>
            <a:r>
              <a:rPr lang="en-US" altLang="ja-JP" sz="1200" dirty="0"/>
              <a:t>R-ANOVA</a:t>
            </a:r>
            <a:r>
              <a:rPr lang="ja-JP" altLang="en-US" sz="1200" dirty="0"/>
              <a:t>　</a:t>
            </a:r>
            <a:r>
              <a:rPr lang="en-US" altLang="ja-JP" sz="1200" dirty="0"/>
              <a:t>p=0.035</a:t>
            </a:r>
            <a:r>
              <a:rPr lang="ja-JP" altLang="en-US" sz="1200" dirty="0"/>
              <a:t>　</a:t>
            </a:r>
            <a:r>
              <a:rPr lang="en-US" altLang="ja-JP" sz="1200" dirty="0"/>
              <a:t>Z&lt;S (0.065)</a:t>
            </a: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149258" y="4626194"/>
            <a:ext cx="2853731" cy="6880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50000"/>
              </a:lnSpc>
            </a:pPr>
            <a:r>
              <a:rPr lang="en-US" altLang="ja-JP" dirty="0"/>
              <a:t>Fig.S1 (a). N3 sleep stage </a:t>
            </a:r>
            <a:r>
              <a:rPr lang="ja-JP" altLang="en-US" sz="3200">
                <a:solidFill>
                  <a:prstClr val="black"/>
                </a:solidFill>
              </a:rPr>
              <a:t>　</a:t>
            </a:r>
            <a:endParaRPr lang="en-US" altLang="ja-JP" sz="3200" dirty="0">
              <a:solidFill>
                <a:prstClr val="black"/>
              </a:solidFill>
            </a:endParaRPr>
          </a:p>
          <a:p>
            <a:pPr algn="ctr">
              <a:lnSpc>
                <a:spcPct val="50000"/>
              </a:lnSpc>
            </a:pPr>
            <a:r>
              <a:rPr lang="en-US" altLang="ja-JP" sz="1200" dirty="0">
                <a:solidFill>
                  <a:prstClr val="black"/>
                </a:solidFill>
              </a:rPr>
              <a:t>R-ANOVA </a:t>
            </a:r>
            <a:r>
              <a:rPr lang="ja-JP" altLang="en-US" sz="1200" dirty="0">
                <a:solidFill>
                  <a:prstClr val="black"/>
                </a:solidFill>
              </a:rPr>
              <a:t> </a:t>
            </a:r>
            <a:r>
              <a:rPr lang="en-US" altLang="ja-JP" sz="1200" dirty="0">
                <a:solidFill>
                  <a:prstClr val="black"/>
                </a:solidFill>
              </a:rPr>
              <a:t>p=0.006</a:t>
            </a:r>
            <a:r>
              <a:rPr lang="ja-JP" altLang="en-US" sz="2400" dirty="0">
                <a:solidFill>
                  <a:prstClr val="black"/>
                </a:solidFill>
              </a:rPr>
              <a:t>　</a:t>
            </a:r>
            <a:endParaRPr lang="en-US" altLang="ja-JP" sz="2400" dirty="0">
              <a:solidFill>
                <a:prstClr val="black"/>
              </a:solidFill>
            </a:endParaRPr>
          </a:p>
          <a:p>
            <a:pPr algn="ctr">
              <a:lnSpc>
                <a:spcPct val="50000"/>
              </a:lnSpc>
            </a:pP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850419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5">
            <a:extLst>
              <a:ext uri="{FF2B5EF4-FFF2-40B4-BE49-F238E27FC236}">
                <a16:creationId xmlns:a16="http://schemas.microsoft.com/office/drawing/2014/main" id="{102D0597-ADCC-4965-BFF3-701E6C26993E}"/>
              </a:ext>
            </a:extLst>
          </p:cNvPr>
          <p:cNvSpPr txBox="1"/>
          <p:nvPr/>
        </p:nvSpPr>
        <p:spPr>
          <a:xfrm>
            <a:off x="1547664" y="2804718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S2-1. TUG</a:t>
            </a:r>
            <a:endParaRPr kumimoji="1" lang="ja-JP" altLang="en-US" dirty="0"/>
          </a:p>
        </p:txBody>
      </p:sp>
      <p:graphicFrame>
        <p:nvGraphicFramePr>
          <p:cNvPr id="3" name="グラフ 6">
            <a:extLst>
              <a:ext uri="{FF2B5EF4-FFF2-40B4-BE49-F238E27FC236}">
                <a16:creationId xmlns:a16="http://schemas.microsoft.com/office/drawing/2014/main" id="{02F2F64E-6352-41B4-85D5-F91864F57A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65057679"/>
              </p:ext>
            </p:extLst>
          </p:nvPr>
        </p:nvGraphicFramePr>
        <p:xfrm>
          <a:off x="4499992" y="183061"/>
          <a:ext cx="4392488" cy="25210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7">
            <a:extLst>
              <a:ext uri="{FF2B5EF4-FFF2-40B4-BE49-F238E27FC236}">
                <a16:creationId xmlns:a16="http://schemas.microsoft.com/office/drawing/2014/main" id="{73C57558-A011-47B1-AE60-31BE00DBEF25}"/>
              </a:ext>
            </a:extLst>
          </p:cNvPr>
          <p:cNvSpPr txBox="1"/>
          <p:nvPr/>
        </p:nvSpPr>
        <p:spPr>
          <a:xfrm>
            <a:off x="5868144" y="2852936"/>
            <a:ext cx="1371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S2-2. FRT</a:t>
            </a:r>
            <a:endParaRPr kumimoji="1" lang="ja-JP" altLang="en-US" dirty="0"/>
          </a:p>
        </p:txBody>
      </p:sp>
      <p:sp>
        <p:nvSpPr>
          <p:cNvPr id="5" name="テキスト ボックス 9">
            <a:extLst>
              <a:ext uri="{FF2B5EF4-FFF2-40B4-BE49-F238E27FC236}">
                <a16:creationId xmlns:a16="http://schemas.microsoft.com/office/drawing/2014/main" id="{28F6B976-3DC2-4115-AEE0-BC44BC4E58CA}"/>
              </a:ext>
            </a:extLst>
          </p:cNvPr>
          <p:cNvSpPr txBox="1"/>
          <p:nvPr/>
        </p:nvSpPr>
        <p:spPr>
          <a:xfrm>
            <a:off x="729789" y="6124611"/>
            <a:ext cx="35736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S2-3. Body sway test (</a:t>
            </a:r>
            <a:r>
              <a:rPr lang="en-US" altLang="ja-JP" dirty="0"/>
              <a:t>eyes open)</a:t>
            </a:r>
            <a:endParaRPr kumimoji="1" lang="ja-JP" altLang="en-US" dirty="0"/>
          </a:p>
        </p:txBody>
      </p:sp>
      <p:graphicFrame>
        <p:nvGraphicFramePr>
          <p:cNvPr id="6" name="グラフ 17">
            <a:extLst>
              <a:ext uri="{FF2B5EF4-FFF2-40B4-BE49-F238E27FC236}">
                <a16:creationId xmlns:a16="http://schemas.microsoft.com/office/drawing/2014/main" id="{459F4810-2B8D-49DE-B570-16D19B2E1D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4207154"/>
              </p:ext>
            </p:extLst>
          </p:nvPr>
        </p:nvGraphicFramePr>
        <p:xfrm>
          <a:off x="308425" y="183061"/>
          <a:ext cx="4392488" cy="27103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18">
            <a:extLst>
              <a:ext uri="{FF2B5EF4-FFF2-40B4-BE49-F238E27FC236}">
                <a16:creationId xmlns:a16="http://schemas.microsoft.com/office/drawing/2014/main" id="{87A565B4-EF86-4166-BCDE-34324FB8E0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3481314"/>
              </p:ext>
            </p:extLst>
          </p:nvPr>
        </p:nvGraphicFramePr>
        <p:xfrm>
          <a:off x="161764" y="338630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36C59CB-FC8C-7444-AD97-F86F5A3522F4}"/>
              </a:ext>
            </a:extLst>
          </p:cNvPr>
          <p:cNvSpPr txBox="1"/>
          <p:nvPr/>
        </p:nvSpPr>
        <p:spPr>
          <a:xfrm>
            <a:off x="1043608" y="6485274"/>
            <a:ext cx="62127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solidFill>
                  <a:prstClr val="black"/>
                </a:solidFill>
              </a:rPr>
              <a:t>Fig.S2 </a:t>
            </a:r>
            <a:r>
              <a:rPr lang="en-US" altLang="ja-JP" b="1" dirty="0"/>
              <a:t>Objective assessments of dynamic and static balance </a:t>
            </a:r>
            <a:endParaRPr lang="ja-JP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3661768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7670847"/>
              </p:ext>
            </p:extLst>
          </p:nvPr>
        </p:nvGraphicFramePr>
        <p:xfrm>
          <a:off x="24935" y="-2738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1835696" y="2896318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S3-</a:t>
            </a:r>
            <a:r>
              <a:rPr lang="en-US" altLang="ja-JP" dirty="0"/>
              <a:t>1</a:t>
            </a:r>
            <a:r>
              <a:rPr kumimoji="1" lang="en-US" altLang="ja-JP" dirty="0"/>
              <a:t>. CFF</a:t>
            </a:r>
            <a:endParaRPr kumimoji="1" lang="ja-JP" altLang="en-US" dirty="0"/>
          </a:p>
        </p:txBody>
      </p:sp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5584983"/>
              </p:ext>
            </p:extLst>
          </p:nvPr>
        </p:nvGraphicFramePr>
        <p:xfrm>
          <a:off x="4596935" y="9102"/>
          <a:ext cx="4572000" cy="2887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9805874"/>
              </p:ext>
            </p:extLst>
          </p:nvPr>
        </p:nvGraphicFramePr>
        <p:xfrm>
          <a:off x="4415191" y="3399296"/>
          <a:ext cx="4753744" cy="27677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5868144" y="2879553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S3-</a:t>
            </a:r>
            <a:r>
              <a:rPr lang="en-US" altLang="ja-JP" dirty="0"/>
              <a:t>2</a:t>
            </a:r>
            <a:r>
              <a:rPr kumimoji="1" lang="en-US" altLang="ja-JP" dirty="0"/>
              <a:t>. SDR-</a:t>
            </a:r>
            <a:r>
              <a:rPr lang="en-US" altLang="ja-JP" dirty="0"/>
              <a:t>r</a:t>
            </a:r>
            <a:r>
              <a:rPr kumimoji="1" lang="en-US" altLang="ja-JP" dirty="0"/>
              <a:t>ate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475656" y="6168202"/>
            <a:ext cx="1989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S3-</a:t>
            </a:r>
            <a:r>
              <a:rPr lang="en-US" altLang="ja-JP" dirty="0"/>
              <a:t>3</a:t>
            </a:r>
            <a:r>
              <a:rPr kumimoji="1" lang="en-US" altLang="ja-JP" dirty="0"/>
              <a:t>. SDR-time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084168" y="6167084"/>
            <a:ext cx="1656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S3-</a:t>
            </a:r>
            <a:r>
              <a:rPr lang="en-US" altLang="ja-JP" dirty="0"/>
              <a:t>4</a:t>
            </a:r>
            <a:r>
              <a:rPr kumimoji="1" lang="en-US" altLang="ja-JP" dirty="0"/>
              <a:t>. STM</a:t>
            </a:r>
            <a:endParaRPr kumimoji="1" lang="ja-JP" altLang="en-US" dirty="0"/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00000000-0008-0000-02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3043409"/>
              </p:ext>
            </p:extLst>
          </p:nvPr>
        </p:nvGraphicFramePr>
        <p:xfrm>
          <a:off x="107504" y="3446152"/>
          <a:ext cx="4535507" cy="26116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FC1E199-172B-49A8-A4BD-903054FE1851}"/>
              </a:ext>
            </a:extLst>
          </p:cNvPr>
          <p:cNvSpPr txBox="1"/>
          <p:nvPr/>
        </p:nvSpPr>
        <p:spPr>
          <a:xfrm>
            <a:off x="1043608" y="6485274"/>
            <a:ext cx="62127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solidFill>
                  <a:prstClr val="black"/>
                </a:solidFill>
              </a:rPr>
              <a:t>Fig.S3 Additional objective assessments</a:t>
            </a:r>
            <a:endParaRPr lang="ja-JP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91118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2555776" y="6308100"/>
            <a:ext cx="38884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solidFill>
                  <a:prstClr val="black"/>
                </a:solidFill>
              </a:rPr>
              <a:t>Fig.S4</a:t>
            </a:r>
            <a:r>
              <a:rPr lang="ja-JP" altLang="en-US" sz="2000" b="1" dirty="0">
                <a:solidFill>
                  <a:prstClr val="black"/>
                </a:solidFill>
              </a:rPr>
              <a:t>　</a:t>
            </a:r>
            <a:r>
              <a:rPr lang="en-US" altLang="ja-JP" sz="2000" b="1" dirty="0">
                <a:solidFill>
                  <a:prstClr val="black"/>
                </a:solidFill>
              </a:rPr>
              <a:t> Subjective assessments</a:t>
            </a:r>
            <a:endParaRPr lang="ja-JP" altLang="en-US" sz="2000" b="1" dirty="0">
              <a:solidFill>
                <a:prstClr val="black"/>
              </a:solidFill>
            </a:endParaRPr>
          </a:p>
        </p:txBody>
      </p:sp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1759962"/>
              </p:ext>
            </p:extLst>
          </p:nvPr>
        </p:nvGraphicFramePr>
        <p:xfrm>
          <a:off x="4499992" y="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5606358"/>
              </p:ext>
            </p:extLst>
          </p:nvPr>
        </p:nvGraphicFramePr>
        <p:xfrm>
          <a:off x="-8066" y="306896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6109140"/>
              </p:ext>
            </p:extLst>
          </p:nvPr>
        </p:nvGraphicFramePr>
        <p:xfrm>
          <a:off x="4506811" y="306896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1547664" y="2699628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S4-1. SSS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5813884" y="2643430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S4-2. Alertness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187624" y="5826371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S4-3. Well-being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940152" y="5875464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S4-4. Fatigue</a:t>
            </a:r>
            <a:endParaRPr kumimoji="1" lang="ja-JP" altLang="en-US" dirty="0"/>
          </a:p>
        </p:txBody>
      </p:sp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00000000-0008-0000-04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9859360"/>
              </p:ext>
            </p:extLst>
          </p:nvPr>
        </p:nvGraphicFramePr>
        <p:xfrm>
          <a:off x="179512" y="149790"/>
          <a:ext cx="4572000" cy="26262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297654930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577</Words>
  <Application>Microsoft Macintosh PowerPoint</Application>
  <PresentationFormat>画面に合わせる (4:3)</PresentationFormat>
  <Paragraphs>225</Paragraphs>
  <Slides>6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2" baseType="lpstr">
      <vt:lpstr>ＭＳ Ｐゴシック</vt:lpstr>
      <vt:lpstr>游ゴシック</vt:lpstr>
      <vt:lpstr>Arial</vt:lpstr>
      <vt:lpstr>Calibri</vt:lpstr>
      <vt:lpstr>Tahoma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　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神林</dc:creator>
  <cp:lastModifiedBy>KanbayashiTakashi</cp:lastModifiedBy>
  <cp:revision>5</cp:revision>
  <dcterms:created xsi:type="dcterms:W3CDTF">2021-09-03T07:34:38Z</dcterms:created>
  <dcterms:modified xsi:type="dcterms:W3CDTF">2022-02-28T09:57:12Z</dcterms:modified>
</cp:coreProperties>
</file>